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notesSlides/notesSlide2.xml" ContentType="application/vnd.openxmlformats-officedocument.presentationml.notesSlide+xml"/>
  <Override PartName="/ppt/charts/chart2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3.xml" ContentType="application/vnd.openxmlformats-officedocument.presentationml.notesSlide+xml"/>
  <Override PartName="/ppt/charts/chart3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notesSlides/notesSlide4.xml" ContentType="application/vnd.openxmlformats-officedocument.presentationml.notesSlide+xml"/>
  <Override PartName="/ppt/charts/chart4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notesSlides/notesSlide5.xml" ContentType="application/vnd.openxmlformats-officedocument.presentationml.notesSlide+xml"/>
  <Override PartName="/ppt/charts/chart5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notesSlides/notesSlide6.xml" ContentType="application/vnd.openxmlformats-officedocument.presentationml.notesSlide+xml"/>
  <Override PartName="/ppt/charts/chart6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notesSlides/notesSlide7.xml" ContentType="application/vnd.openxmlformats-officedocument.presentationml.notesSlide+xml"/>
  <Override PartName="/ppt/charts/chart7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notesSlides/notesSlide8.xml" ContentType="application/vnd.openxmlformats-officedocument.presentationml.notesSlide+xml"/>
  <Override PartName="/ppt/charts/chart8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notesSlides/notesSlide9.xml" ContentType="application/vnd.openxmlformats-officedocument.presentationml.notesSlide+xml"/>
  <Override PartName="/ppt/charts/chart9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5"/>
  </p:notesMasterIdLst>
  <p:handoutMasterIdLst>
    <p:handoutMasterId r:id="rId16"/>
  </p:handoutMasterIdLst>
  <p:sldIdLst>
    <p:sldId id="402" r:id="rId2"/>
    <p:sldId id="415" r:id="rId3"/>
    <p:sldId id="416" r:id="rId4"/>
    <p:sldId id="412" r:id="rId5"/>
    <p:sldId id="422" r:id="rId6"/>
    <p:sldId id="417" r:id="rId7"/>
    <p:sldId id="413" r:id="rId8"/>
    <p:sldId id="423" r:id="rId9"/>
    <p:sldId id="418" r:id="rId10"/>
    <p:sldId id="414" r:id="rId11"/>
    <p:sldId id="419" r:id="rId12"/>
    <p:sldId id="420" r:id="rId13"/>
    <p:sldId id="421" r:id="rId14"/>
  </p:sldIdLst>
  <p:sldSz cx="9144000" cy="6858000" type="screen4x3"/>
  <p:notesSz cx="9872663" cy="67421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08" userDrawn="1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EB344D84-9AFB-497E-A393-DC336BA19D2E}" styleName="보통 스타일 3 - 강조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9D7B26C5-4107-4FEC-AEDC-1716B250A1EF}" styleName="밝은 스타일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93D81CF-94F2-401A-BA57-92F5A7B2D0C5}" styleName="보통 스타일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144" autoAdjust="0"/>
    <p:restoredTop sz="96866" autoAdjust="0"/>
  </p:normalViewPr>
  <p:slideViewPr>
    <p:cSldViewPr>
      <p:cViewPr>
        <p:scale>
          <a:sx n="150" d="100"/>
          <a:sy n="150" d="100"/>
        </p:scale>
        <p:origin x="-198" y="-558"/>
      </p:cViewPr>
      <p:guideLst>
        <p:guide orient="horz" pos="2208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21" Type="http://schemas.microsoft.com/office/2015/10/relationships/revisionInfo" Target="revisionInfo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handoutMaster" Target="handoutMasters/handoutMaster1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ALAM%20ALL\Documents\PhD%20Course,%20204\My%20work\Lab%20calculation\Shapla\antioxidant\Final%20file\NNF\NNF%20final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ALAM%20ALL\Documents\PhD%20Course,%20204\My%20work\Lab%20calculation\Shapla\antioxidant\Final%20file\NNF\NNF%20final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E:\ALAM%20ALL\Documents\PhD%20Course,%20204\My%20work\Lab%20calculation\Shapla\antioxidant\Final%20file\NNF\NNF%20final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E:\ALAM%20ALL\Documents\PhD%20Course,%20204\My%20work\Lab%20calculation\Shapla\antioxidant\Final%20file\ORAC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E:\ALAM%20ALL\Documents\PhD%20Course,%20204\My%20work\Lab%20calculation\Shapla\antioxidant\Final%20file\NNF\NNF%20final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E:\ALAM%20ALL\Documents\PhD%20Course,%20204\My%20work\Lab%20calculation\Shapla\antioxidant\Final%20file\NNF\NNF%20final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E:\ALAM%20ALL\Documents\PhD%20Course,%20204\My%20work\Lab%20calculation\Shapla\antioxidant\Final%20file\NNF\NNF%20final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E:\ALAM%20ALL\Documents\PhD%20Course,%20204\My%20work\Lab%20calculation\Shapla\antioxidant\Final%20file\NNF\NNF%20final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548538203557888"/>
          <c:y val="2.4305555555555556E-2"/>
          <c:w val="0.77315999562554683"/>
          <c:h val="0.8576388888888888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phenolic content '!$M$78</c:f>
              <c:strCache>
                <c:ptCount val="1"/>
                <c:pt idx="0">
                  <c:v>Total Phenol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 w="15875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phenolic content '!$M$85:$M$89</c:f>
                <c:numCache>
                  <c:formatCode>General</c:formatCode>
                  <c:ptCount val="5"/>
                  <c:pt idx="0">
                    <c:v>0.15421385784492578</c:v>
                  </c:pt>
                  <c:pt idx="1">
                    <c:v>1.6493780863028159E-2</c:v>
                  </c:pt>
                  <c:pt idx="2">
                    <c:v>5.6901210454334369E-2</c:v>
                  </c:pt>
                  <c:pt idx="3">
                    <c:v>5.3620251411738117E-2</c:v>
                  </c:pt>
                  <c:pt idx="4">
                    <c:v>1.0150151508091189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phenolic content '!$L$79:$L$83</c:f>
              <c:strCache>
                <c:ptCount val="5"/>
                <c:pt idx="0">
                  <c:v>NNFM</c:v>
                </c:pt>
                <c:pt idx="1">
                  <c:v>NNFH</c:v>
                </c:pt>
                <c:pt idx="2">
                  <c:v>NNFC</c:v>
                </c:pt>
                <c:pt idx="3">
                  <c:v>NNFE</c:v>
                </c:pt>
                <c:pt idx="4">
                  <c:v>NNFW</c:v>
                </c:pt>
              </c:strCache>
            </c:strRef>
          </c:cat>
          <c:val>
            <c:numRef>
              <c:f>'phenolic content '!$M$79:$M$83</c:f>
              <c:numCache>
                <c:formatCode>0.00</c:formatCode>
                <c:ptCount val="5"/>
                <c:pt idx="0">
                  <c:v>413.22713283459962</c:v>
                </c:pt>
                <c:pt idx="1">
                  <c:v>108.12699178715759</c:v>
                </c:pt>
                <c:pt idx="2">
                  <c:v>206.50045996056647</c:v>
                </c:pt>
                <c:pt idx="3">
                  <c:v>525.1803982118447</c:v>
                </c:pt>
                <c:pt idx="4">
                  <c:v>208.288878014337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67C-4397-A123-D1D54998046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40114176"/>
        <c:axId val="147468288"/>
      </c:barChart>
      <c:lineChart>
        <c:grouping val="standard"/>
        <c:varyColors val="0"/>
        <c:ser>
          <c:idx val="1"/>
          <c:order val="1"/>
          <c:tx>
            <c:strRef>
              <c:f>'phenolic content '!$N$78</c:f>
              <c:strCache>
                <c:ptCount val="1"/>
                <c:pt idx="0">
                  <c:v>Total Flavonoid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dPt>
            <c:idx val="4"/>
            <c:bubble3D val="0"/>
            <c:spPr>
              <a:ln w="15875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2-767C-4397-A123-D1D54998046C}"/>
              </c:ext>
            </c:extLst>
          </c:dPt>
          <c:errBars>
            <c:errDir val="y"/>
            <c:errBarType val="plus"/>
            <c:errValType val="cust"/>
            <c:noEndCap val="0"/>
            <c:plus>
              <c:numRef>
                <c:f>'phenolic content '!$N$85:$N$89</c:f>
                <c:numCache>
                  <c:formatCode>General</c:formatCode>
                  <c:ptCount val="5"/>
                  <c:pt idx="0">
                    <c:v>1.5922309403484821E-2</c:v>
                  </c:pt>
                  <c:pt idx="1">
                    <c:v>1.2483507421998979E-2</c:v>
                  </c:pt>
                  <c:pt idx="2">
                    <c:v>3.2130163324152715E-2</c:v>
                  </c:pt>
                  <c:pt idx="3">
                    <c:v>6.0622595645439675E-2</c:v>
                  </c:pt>
                  <c:pt idx="4">
                    <c:v>8.6210249837781819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9050"/>
            </c:spPr>
          </c:errBars>
          <c:cat>
            <c:strRef>
              <c:f>'phenolic content '!$L$79:$L$83</c:f>
              <c:strCache>
                <c:ptCount val="5"/>
                <c:pt idx="0">
                  <c:v>NNFM</c:v>
                </c:pt>
                <c:pt idx="1">
                  <c:v>NNFH</c:v>
                </c:pt>
                <c:pt idx="2">
                  <c:v>NNFC</c:v>
                </c:pt>
                <c:pt idx="3">
                  <c:v>NNFE</c:v>
                </c:pt>
                <c:pt idx="4">
                  <c:v>NNFW</c:v>
                </c:pt>
              </c:strCache>
            </c:strRef>
          </c:cat>
          <c:val>
            <c:numRef>
              <c:f>'phenolic content '!$N$79:$N$83</c:f>
              <c:numCache>
                <c:formatCode>0.00</c:formatCode>
                <c:ptCount val="5"/>
                <c:pt idx="0">
                  <c:v>54.855293682965097</c:v>
                </c:pt>
                <c:pt idx="1">
                  <c:v>1.6962407946437903</c:v>
                </c:pt>
                <c:pt idx="2">
                  <c:v>21.900623376116354</c:v>
                </c:pt>
                <c:pt idx="3">
                  <c:v>87.540407512905915</c:v>
                </c:pt>
                <c:pt idx="4">
                  <c:v>21.93099436971434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767C-4397-A123-D1D54998046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47471360"/>
        <c:axId val="147469824"/>
      </c:lineChart>
      <c:catAx>
        <c:axId val="1401141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  <a:prstDash val="solid"/>
          </a:ln>
        </c:spPr>
        <c:txPr>
          <a:bodyPr rot="0" vert="horz"/>
          <a:lstStyle/>
          <a:p>
            <a:pPr>
              <a:defRPr sz="1200" b="1" i="0" u="none" strike="noStrike" baseline="0">
                <a:solidFill>
                  <a:srgbClr val="000000"/>
                </a:solidFill>
                <a:latin typeface="Times New Roman" panose="02020603050405020304" pitchFamily="18" charset="0"/>
                <a:ea typeface="Arial"/>
                <a:cs typeface="Times New Roman" panose="02020603050405020304" pitchFamily="18" charset="0"/>
              </a:defRPr>
            </a:pPr>
            <a:endParaRPr lang="en-US"/>
          </a:p>
        </c:txPr>
        <c:crossAx val="147468288"/>
        <c:crosses val="autoZero"/>
        <c:auto val="0"/>
        <c:lblAlgn val="ctr"/>
        <c:lblOffset val="100"/>
        <c:noMultiLvlLbl val="0"/>
      </c:catAx>
      <c:valAx>
        <c:axId val="147468288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ln w="12700">
            <a:solidFill>
              <a:schemeClr val="tx1"/>
            </a:solidFill>
            <a:prstDash val="solid"/>
          </a:ln>
        </c:spPr>
        <c:txPr>
          <a:bodyPr rot="0" vert="horz"/>
          <a:lstStyle/>
          <a:p>
            <a:pPr>
              <a:defRPr sz="1200" b="1" i="0" u="none" strike="noStrike" baseline="0">
                <a:solidFill>
                  <a:srgbClr val="000000"/>
                </a:solidFill>
                <a:latin typeface="Times New Roman" panose="02020603050405020304" pitchFamily="18" charset="0"/>
                <a:ea typeface="Arial"/>
                <a:cs typeface="Times New Roman" panose="02020603050405020304" pitchFamily="18" charset="0"/>
              </a:defRPr>
            </a:pPr>
            <a:endParaRPr lang="en-US"/>
          </a:p>
        </c:txPr>
        <c:crossAx val="140114176"/>
        <c:crosses val="autoZero"/>
        <c:crossBetween val="between"/>
      </c:valAx>
      <c:valAx>
        <c:axId val="147469824"/>
        <c:scaling>
          <c:orientation val="minMax"/>
        </c:scaling>
        <c:delete val="0"/>
        <c:axPos val="r"/>
        <c:numFmt formatCode="0" sourceLinked="0"/>
        <c:majorTickMark val="cross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20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147471360"/>
        <c:crosses val="max"/>
        <c:crossBetween val="between"/>
        <c:majorUnit val="25"/>
      </c:valAx>
      <c:catAx>
        <c:axId val="147471360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47469824"/>
        <c:crosses val="autoZero"/>
        <c:auto val="1"/>
        <c:lblAlgn val="ctr"/>
        <c:lblOffset val="100"/>
        <c:noMultiLvlLbl val="0"/>
      </c:cat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17430555555555557"/>
          <c:y val="4.2960096089683696E-3"/>
          <c:w val="0.4025496062992126"/>
          <c:h val="0.1611806649168854"/>
        </c:manualLayout>
      </c:layout>
      <c:overlay val="0"/>
      <c:spPr>
        <a:noFill/>
        <a:ln w="25400">
          <a:noFill/>
        </a:ln>
      </c:spPr>
      <c:txPr>
        <a:bodyPr/>
        <a:lstStyle/>
        <a:p>
          <a:pPr>
            <a:defRPr sz="1200" b="1" i="0" u="none" strike="noStrike" baseline="0">
              <a:solidFill>
                <a:srgbClr val="000000"/>
              </a:solidFill>
              <a:latin typeface="Times New Roman" panose="02020603050405020304" pitchFamily="18" charset="0"/>
              <a:ea typeface="Arial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12700">
      <a:noFill/>
      <a:prstDash val="solid"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822513444560689"/>
          <c:y val="0.10790056798672362"/>
          <c:w val="0.88444156892975789"/>
          <c:h val="0.60703041881385711"/>
        </c:manualLayout>
      </c:layout>
      <c:barChart>
        <c:barDir val="col"/>
        <c:grouping val="clustered"/>
        <c:varyColors val="0"/>
        <c:ser>
          <c:idx val="0"/>
          <c:order val="0"/>
          <c:tx>
            <c:v>DPPH radical</c:v>
          </c:tx>
          <c:spPr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dLbls>
            <c:dLbl>
              <c:idx val="0"/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B039-4819-84B3-75014FBC2A3A}"/>
                </c:ext>
              </c:extLst>
            </c:dLbl>
            <c:dLbl>
              <c:idx val="1"/>
              <c:layout>
                <c:manualLayout>
                  <c:x val="-1.6188186796952574E-17"/>
                  <c:y val="-1.8359147571767823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B039-4819-84B3-75014FBC2A3A}"/>
                </c:ext>
              </c:extLst>
            </c:dLbl>
            <c:dLbl>
              <c:idx val="2"/>
              <c:layout>
                <c:manualLayout>
                  <c:x val="0"/>
                  <c:y val="-2.7538721357651733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B039-4819-84B3-75014FBC2A3A}"/>
                </c:ext>
              </c:extLst>
            </c:dLbl>
            <c:dLbl>
              <c:idx val="3"/>
              <c:layout>
                <c:manualLayout>
                  <c:x val="-3.5320088300220751E-3"/>
                  <c:y val="-4.130808203647756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B039-4819-84B3-75014FBC2A3A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4-B039-4819-84B3-75014FBC2A3A}"/>
                </c:ext>
              </c:extLst>
            </c:dLbl>
            <c:dLbl>
              <c:idx val="5"/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B039-4819-84B3-75014FBC2A3A}"/>
                </c:ext>
              </c:extLst>
            </c:dLbl>
            <c:dLbl>
              <c:idx val="6"/>
              <c:tx>
                <c:rich>
                  <a:bodyPr/>
                  <a:lstStyle/>
                  <a:p>
                    <a:r>
                      <a:rPr lang="en-US"/>
                      <a:t>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6-B039-4819-84B3-75014FBC2A3A}"/>
                </c:ext>
              </c:extLst>
            </c:dLbl>
            <c:dLbl>
              <c:idx val="7"/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B039-4819-84B3-75014FBC2A3A}"/>
                </c:ext>
              </c:extLst>
            </c:dLbl>
            <c:dLbl>
              <c:idx val="8"/>
              <c:layout>
                <c:manualLayout>
                  <c:x val="-6.4752747187810296E-17"/>
                  <c:y val="-1.3769360678825867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8-B039-4819-84B3-75014FBC2A3A}"/>
                </c:ext>
              </c:extLst>
            </c:dLbl>
            <c:dLbl>
              <c:idx val="9"/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B039-4819-84B3-75014FBC2A3A}"/>
                </c:ext>
              </c:extLst>
            </c:dLbl>
            <c:dLbl>
              <c:idx val="10"/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A-B039-4819-84B3-75014FBC2A3A}"/>
                </c:ext>
              </c:extLst>
            </c:dLbl>
            <c:dLbl>
              <c:idx val="11"/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B039-4819-84B3-75014FBC2A3A}"/>
                </c:ext>
              </c:extLst>
            </c:dLbl>
            <c:dLbl>
              <c:idx val="12"/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C-B039-4819-84B3-75014FBC2A3A}"/>
                </c:ext>
              </c:extLst>
            </c:dLbl>
            <c:dLbl>
              <c:idx val="13"/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D-B039-4819-84B3-75014FBC2A3A}"/>
                </c:ext>
              </c:extLst>
            </c:dLbl>
            <c:dLbl>
              <c:idx val="14"/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E-B039-4819-84B3-75014FBC2A3A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plus"/>
            <c:errValType val="cust"/>
            <c:noEndCap val="0"/>
            <c:plus>
              <c:numRef>
                <c:f>'DPPH (2)'!$M$8:$M$22</c:f>
                <c:numCache>
                  <c:formatCode>General</c:formatCode>
                  <c:ptCount val="15"/>
                  <c:pt idx="0">
                    <c:v>1.3211701334277277</c:v>
                  </c:pt>
                  <c:pt idx="1">
                    <c:v>2.7042413537061507</c:v>
                  </c:pt>
                  <c:pt idx="2">
                    <c:v>2.3544780699473438</c:v>
                  </c:pt>
                  <c:pt idx="3">
                    <c:v>1.4641257840487432</c:v>
                  </c:pt>
                  <c:pt idx="4">
                    <c:v>0.28656803273792392</c:v>
                  </c:pt>
                  <c:pt idx="5">
                    <c:v>2.599193112165481</c:v>
                  </c:pt>
                  <c:pt idx="6">
                    <c:v>3.5185659923515091</c:v>
                  </c:pt>
                  <c:pt idx="7">
                    <c:v>2.1408897621938192</c:v>
                  </c:pt>
                  <c:pt idx="8">
                    <c:v>0.88262638942035032</c:v>
                  </c:pt>
                  <c:pt idx="9">
                    <c:v>1.7134310178272669</c:v>
                  </c:pt>
                  <c:pt idx="10">
                    <c:v>2.2507127401810965</c:v>
                  </c:pt>
                  <c:pt idx="11">
                    <c:v>0.23210317437259698</c:v>
                  </c:pt>
                  <c:pt idx="12">
                    <c:v>0.55559020544564985</c:v>
                  </c:pt>
                  <c:pt idx="13">
                    <c:v>2.1082893407560985</c:v>
                  </c:pt>
                  <c:pt idx="14">
                    <c:v>0.219191912375857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DPPH (2)'!$D$8:$E$22</c:f>
              <c:multiLvlStrCache>
                <c:ptCount val="15"/>
                <c:lvl>
                  <c:pt idx="0">
                    <c:v>3</c:v>
                  </c:pt>
                  <c:pt idx="1">
                    <c:v>10</c:v>
                  </c:pt>
                  <c:pt idx="2">
                    <c:v>30</c:v>
                  </c:pt>
                  <c:pt idx="3">
                    <c:v>3</c:v>
                  </c:pt>
                  <c:pt idx="4">
                    <c:v>10</c:v>
                  </c:pt>
                  <c:pt idx="5">
                    <c:v>30</c:v>
                  </c:pt>
                  <c:pt idx="6">
                    <c:v>3</c:v>
                  </c:pt>
                  <c:pt idx="7">
                    <c:v>10</c:v>
                  </c:pt>
                  <c:pt idx="8">
                    <c:v>30</c:v>
                  </c:pt>
                  <c:pt idx="9">
                    <c:v>3</c:v>
                  </c:pt>
                  <c:pt idx="10">
                    <c:v>10</c:v>
                  </c:pt>
                  <c:pt idx="11">
                    <c:v>30</c:v>
                  </c:pt>
                  <c:pt idx="12">
                    <c:v>3</c:v>
                  </c:pt>
                  <c:pt idx="13">
                    <c:v>10</c:v>
                  </c:pt>
                  <c:pt idx="14">
                    <c:v>30</c:v>
                  </c:pt>
                </c:lvl>
                <c:lvl>
                  <c:pt idx="0">
                    <c:v>Ascorbic acid
(µg/mL) </c:v>
                  </c:pt>
                  <c:pt idx="3">
                    <c:v>NNFM
(µg/mL) </c:v>
                  </c:pt>
                  <c:pt idx="6">
                    <c:v>NNFH
(µg/mL) </c:v>
                  </c:pt>
                  <c:pt idx="9">
                    <c:v>NNFC
(µg/mL) </c:v>
                  </c:pt>
                  <c:pt idx="12">
                    <c:v>NNFW
(µg/mL) </c:v>
                  </c:pt>
                </c:lvl>
              </c:multiLvlStrCache>
            </c:multiLvlStrRef>
          </c:cat>
          <c:val>
            <c:numRef>
              <c:f>'DPPH (2)'!$L$8:$L$22</c:f>
              <c:numCache>
                <c:formatCode>0.00</c:formatCode>
                <c:ptCount val="15"/>
                <c:pt idx="0">
                  <c:v>16.68121404154979</c:v>
                </c:pt>
                <c:pt idx="1">
                  <c:v>39.840213209330628</c:v>
                </c:pt>
                <c:pt idx="2">
                  <c:v>65.609033297429519</c:v>
                </c:pt>
                <c:pt idx="3">
                  <c:v>43.238511474507959</c:v>
                </c:pt>
                <c:pt idx="4">
                  <c:v>64.324824806999246</c:v>
                </c:pt>
                <c:pt idx="5">
                  <c:v>88.485144816795369</c:v>
                </c:pt>
                <c:pt idx="6">
                  <c:v>27.317021281164671</c:v>
                </c:pt>
                <c:pt idx="7">
                  <c:v>44.898102310630975</c:v>
                </c:pt>
                <c:pt idx="8">
                  <c:v>71.214784317995466</c:v>
                </c:pt>
                <c:pt idx="9">
                  <c:v>31.175876559686596</c:v>
                </c:pt>
                <c:pt idx="10">
                  <c:v>56.251484499789989</c:v>
                </c:pt>
                <c:pt idx="11">
                  <c:v>74.495223319121749</c:v>
                </c:pt>
                <c:pt idx="12">
                  <c:v>38.431545670334259</c:v>
                </c:pt>
                <c:pt idx="13">
                  <c:v>72.359202661596456</c:v>
                </c:pt>
                <c:pt idx="14">
                  <c:v>85.0000136218452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F-B039-4819-84B3-75014FBC2A3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52535424"/>
        <c:axId val="152536960"/>
      </c:barChart>
      <c:lineChart>
        <c:grouping val="standard"/>
        <c:varyColors val="0"/>
        <c:ser>
          <c:idx val="1"/>
          <c:order val="1"/>
          <c:tx>
            <c:v>ABTS radical</c:v>
          </c:tx>
          <c:spPr>
            <a:ln w="158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ABTS (2)'!$M$8:$M$22</c:f>
                <c:numCache>
                  <c:formatCode>General</c:formatCode>
                  <c:ptCount val="15"/>
                  <c:pt idx="0">
                    <c:v>2.1988823203223884</c:v>
                  </c:pt>
                  <c:pt idx="1">
                    <c:v>1.2270878181954941</c:v>
                  </c:pt>
                  <c:pt idx="2">
                    <c:v>0.95575823845579699</c:v>
                  </c:pt>
                  <c:pt idx="3">
                    <c:v>0.72093408786399893</c:v>
                  </c:pt>
                  <c:pt idx="4">
                    <c:v>0.10961989342793264</c:v>
                  </c:pt>
                  <c:pt idx="5">
                    <c:v>0.75850932149283845</c:v>
                  </c:pt>
                  <c:pt idx="6">
                    <c:v>1.6384287582516877</c:v>
                  </c:pt>
                  <c:pt idx="7">
                    <c:v>1.4231501103766713</c:v>
                  </c:pt>
                  <c:pt idx="8">
                    <c:v>1.4819971836725345</c:v>
                  </c:pt>
                  <c:pt idx="9">
                    <c:v>0.54713377802971741</c:v>
                  </c:pt>
                  <c:pt idx="10">
                    <c:v>1.235772585731769</c:v>
                  </c:pt>
                  <c:pt idx="11">
                    <c:v>1.7808909107261548</c:v>
                  </c:pt>
                  <c:pt idx="12">
                    <c:v>0.94223175039553142</c:v>
                  </c:pt>
                  <c:pt idx="13">
                    <c:v>0.73189595157032494</c:v>
                  </c:pt>
                  <c:pt idx="14">
                    <c:v>1.037575025641161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DPPH (2)'!$L$27:$L$41</c:f>
              <c:numCache>
                <c:formatCode>General</c:formatCode>
                <c:ptCount val="15"/>
                <c:pt idx="0">
                  <c:v>9.9694727556714771</c:v>
                </c:pt>
                <c:pt idx="1">
                  <c:v>43.678230159031898</c:v>
                </c:pt>
                <c:pt idx="2">
                  <c:v>71.683417044819791</c:v>
                </c:pt>
                <c:pt idx="3">
                  <c:v>49.724765056238446</c:v>
                </c:pt>
                <c:pt idx="4">
                  <c:v>85.861869528227359</c:v>
                </c:pt>
                <c:pt idx="5">
                  <c:v>90.096485863758588</c:v>
                </c:pt>
                <c:pt idx="6">
                  <c:v>18.586491841718097</c:v>
                </c:pt>
                <c:pt idx="7">
                  <c:v>37.895857136265086</c:v>
                </c:pt>
                <c:pt idx="8">
                  <c:v>75.915709447897441</c:v>
                </c:pt>
                <c:pt idx="9">
                  <c:v>26.171781303568014</c:v>
                </c:pt>
                <c:pt idx="10">
                  <c:v>59.936791967213104</c:v>
                </c:pt>
                <c:pt idx="11">
                  <c:v>74.548802416983932</c:v>
                </c:pt>
                <c:pt idx="12">
                  <c:v>29.912861502691083</c:v>
                </c:pt>
                <c:pt idx="13">
                  <c:v>66.05003807514457</c:v>
                </c:pt>
                <c:pt idx="14">
                  <c:v>88.01138051143108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0-B039-4819-84B3-75014FBC2A3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52568960"/>
        <c:axId val="152538496"/>
      </c:lineChart>
      <c:catAx>
        <c:axId val="1525354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2536960"/>
        <c:crosses val="autoZero"/>
        <c:auto val="1"/>
        <c:lblAlgn val="ctr"/>
        <c:lblOffset val="100"/>
        <c:noMultiLvlLbl val="0"/>
      </c:catAx>
      <c:valAx>
        <c:axId val="152536960"/>
        <c:scaling>
          <c:orientation val="minMax"/>
          <c:max val="100"/>
          <c:min val="0"/>
        </c:scaling>
        <c:delete val="0"/>
        <c:axPos val="l"/>
        <c:numFmt formatCode="0" sourceLinked="0"/>
        <c:majorTickMark val="cross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2535424"/>
        <c:crosses val="autoZero"/>
        <c:crossBetween val="between"/>
        <c:majorUnit val="25"/>
      </c:valAx>
      <c:valAx>
        <c:axId val="152538496"/>
        <c:scaling>
          <c:orientation val="minMax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2568960"/>
        <c:crosses val="max"/>
        <c:crossBetween val="between"/>
        <c:majorUnit val="25"/>
      </c:valAx>
      <c:catAx>
        <c:axId val="152568960"/>
        <c:scaling>
          <c:orientation val="minMax"/>
        </c:scaling>
        <c:delete val="1"/>
        <c:axPos val="b"/>
        <c:majorTickMark val="out"/>
        <c:minorTickMark val="none"/>
        <c:tickLblPos val="nextTo"/>
        <c:crossAx val="152538496"/>
        <c:crosses val="autoZero"/>
        <c:auto val="1"/>
        <c:lblAlgn val="ctr"/>
        <c:lblOffset val="100"/>
        <c:noMultiLvlLbl val="0"/>
      </c:catAx>
      <c:spPr>
        <a:noFill/>
        <a:ln w="12700">
          <a:noFill/>
        </a:ln>
        <a:effectLst/>
      </c:spPr>
    </c:plotArea>
    <c:legend>
      <c:legendPos val="r"/>
      <c:layout>
        <c:manualLayout>
          <c:xMode val="edge"/>
          <c:yMode val="edge"/>
          <c:x val="0.4588254680085519"/>
          <c:y val="9.4658030157429678E-3"/>
          <c:w val="0.36810609932036642"/>
          <c:h val="9.793155378653788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6.1004036794754517E-2"/>
          <c:y val="0.10911126104228615"/>
          <c:w val="0.88677960097038067"/>
          <c:h val="0.60783309406011776"/>
        </c:manualLayout>
      </c:layout>
      <c:barChart>
        <c:barDir val="col"/>
        <c:grouping val="clustered"/>
        <c:varyColors val="0"/>
        <c:ser>
          <c:idx val="0"/>
          <c:order val="0"/>
          <c:tx>
            <c:v>Hydroxyl radical</c:v>
          </c:tx>
          <c:spPr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dLbls>
            <c:dLbl>
              <c:idx val="0"/>
              <c:tx>
                <c:rich>
                  <a:bodyPr/>
                  <a:lstStyle/>
                  <a:p>
                    <a:r>
                      <a:rPr lang="en-US" altLang="ko-KR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DBFA-4096-8A4E-F0D1816F76F2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r>
                      <a:rPr lang="en-US" altLang="ko-KR" dirty="0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DBFA-4096-8A4E-F0D1816F76F2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r>
                      <a:rPr lang="en-US" altLang="ko-KR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DBFA-4096-8A4E-F0D1816F76F2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r>
                      <a:rPr lang="en-US" altLang="ko-KR"/>
                      <a:t>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DBFA-4096-8A4E-F0D1816F76F2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r>
                      <a:rPr lang="en-US" altLang="ko-KR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4-DBFA-4096-8A4E-F0D1816F76F2}"/>
                </c:ext>
              </c:extLst>
            </c:dLbl>
            <c:dLbl>
              <c:idx val="5"/>
              <c:tx>
                <c:rich>
                  <a:bodyPr/>
                  <a:lstStyle/>
                  <a:p>
                    <a:r>
                      <a:rPr lang="en-US" altLang="ko-KR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DBFA-4096-8A4E-F0D1816F76F2}"/>
                </c:ext>
              </c:extLst>
            </c:dLbl>
            <c:dLbl>
              <c:idx val="6"/>
              <c:tx>
                <c:rich>
                  <a:bodyPr/>
                  <a:lstStyle/>
                  <a:p>
                    <a:r>
                      <a:rPr lang="en-US" altLang="ko-KR"/>
                      <a:t>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6-DBFA-4096-8A4E-F0D1816F76F2}"/>
                </c:ext>
              </c:extLst>
            </c:dLbl>
            <c:dLbl>
              <c:idx val="7"/>
              <c:tx>
                <c:rich>
                  <a:bodyPr/>
                  <a:lstStyle/>
                  <a:p>
                    <a:r>
                      <a:rPr lang="en-US" altLang="ko-KR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DBFA-4096-8A4E-F0D1816F76F2}"/>
                </c:ext>
              </c:extLst>
            </c:dLbl>
            <c:dLbl>
              <c:idx val="8"/>
              <c:tx>
                <c:rich>
                  <a:bodyPr/>
                  <a:lstStyle/>
                  <a:p>
                    <a:r>
                      <a:rPr lang="en-US" altLang="ko-KR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8-DBFA-4096-8A4E-F0D1816F76F2}"/>
                </c:ext>
              </c:extLst>
            </c:dLbl>
            <c:dLbl>
              <c:idx val="9"/>
              <c:tx>
                <c:rich>
                  <a:bodyPr/>
                  <a:lstStyle/>
                  <a:p>
                    <a:r>
                      <a:rPr lang="en-US" altLang="ko-KR"/>
                      <a:t>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DBFA-4096-8A4E-F0D1816F76F2}"/>
                </c:ext>
              </c:extLst>
            </c:dLbl>
            <c:dLbl>
              <c:idx val="10"/>
              <c:tx>
                <c:rich>
                  <a:bodyPr/>
                  <a:lstStyle/>
                  <a:p>
                    <a:r>
                      <a:rPr lang="en-US" altLang="ko-KR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A-DBFA-4096-8A4E-F0D1816F76F2}"/>
                </c:ext>
              </c:extLst>
            </c:dLbl>
            <c:dLbl>
              <c:idx val="11"/>
              <c:tx>
                <c:rich>
                  <a:bodyPr/>
                  <a:lstStyle/>
                  <a:p>
                    <a:r>
                      <a:rPr lang="en-US" altLang="ko-KR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DBFA-4096-8A4E-F0D1816F76F2}"/>
                </c:ext>
              </c:extLst>
            </c:dLbl>
            <c:dLbl>
              <c:idx val="12"/>
              <c:tx>
                <c:rich>
                  <a:bodyPr/>
                  <a:lstStyle/>
                  <a:p>
                    <a:r>
                      <a:rPr lang="en-US" altLang="ko-KR"/>
                      <a:t>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C-DBFA-4096-8A4E-F0D1816F76F2}"/>
                </c:ext>
              </c:extLst>
            </c:dLbl>
            <c:dLbl>
              <c:idx val="13"/>
              <c:tx>
                <c:rich>
                  <a:bodyPr/>
                  <a:lstStyle/>
                  <a:p>
                    <a:r>
                      <a:rPr lang="en-US" altLang="ko-KR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D-DBFA-4096-8A4E-F0D1816F76F2}"/>
                </c:ext>
              </c:extLst>
            </c:dLbl>
            <c:dLbl>
              <c:idx val="14"/>
              <c:tx>
                <c:rich>
                  <a:bodyPr/>
                  <a:lstStyle/>
                  <a:p>
                    <a:r>
                      <a:rPr lang="en-US" altLang="ko-KR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E-DBFA-4096-8A4E-F0D1816F76F2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plus"/>
            <c:errValType val="cust"/>
            <c:noEndCap val="0"/>
            <c:plus>
              <c:numRef>
                <c:f>'HO radical (2)'!$M$8:$M$22</c:f>
                <c:numCache>
                  <c:formatCode>General</c:formatCode>
                  <c:ptCount val="15"/>
                  <c:pt idx="0">
                    <c:v>2.8203220796045243</c:v>
                  </c:pt>
                  <c:pt idx="1">
                    <c:v>0.28668810515756649</c:v>
                  </c:pt>
                  <c:pt idx="2">
                    <c:v>7.2069150277798907E-2</c:v>
                  </c:pt>
                  <c:pt idx="3">
                    <c:v>1.3034325359085523</c:v>
                  </c:pt>
                  <c:pt idx="4">
                    <c:v>1.4972248922637021</c:v>
                  </c:pt>
                  <c:pt idx="5">
                    <c:v>1.5860917300849573</c:v>
                  </c:pt>
                  <c:pt idx="6">
                    <c:v>2.2534613250177782</c:v>
                  </c:pt>
                  <c:pt idx="7">
                    <c:v>2.5703646724222833</c:v>
                  </c:pt>
                  <c:pt idx="8">
                    <c:v>1.9574330117350887</c:v>
                  </c:pt>
                  <c:pt idx="9">
                    <c:v>1.3219490000792928</c:v>
                  </c:pt>
                  <c:pt idx="10">
                    <c:v>2.9281894556353141</c:v>
                  </c:pt>
                  <c:pt idx="11">
                    <c:v>2.7470967611618868</c:v>
                  </c:pt>
                  <c:pt idx="12">
                    <c:v>2.0016264300623661</c:v>
                  </c:pt>
                  <c:pt idx="13">
                    <c:v>2.8143467611766999</c:v>
                  </c:pt>
                  <c:pt idx="14">
                    <c:v>3.210786040951627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HO radical (2)'!$D$8:$E$22</c:f>
              <c:multiLvlStrCache>
                <c:ptCount val="15"/>
                <c:lvl>
                  <c:pt idx="0">
                    <c:v>0.3</c:v>
                  </c:pt>
                  <c:pt idx="1">
                    <c:v>1</c:v>
                  </c:pt>
                  <c:pt idx="2">
                    <c:v>3</c:v>
                  </c:pt>
                  <c:pt idx="3">
                    <c:v>3</c:v>
                  </c:pt>
                  <c:pt idx="4">
                    <c:v>10</c:v>
                  </c:pt>
                  <c:pt idx="5">
                    <c:v>30</c:v>
                  </c:pt>
                  <c:pt idx="6">
                    <c:v>3</c:v>
                  </c:pt>
                  <c:pt idx="7">
                    <c:v>10</c:v>
                  </c:pt>
                  <c:pt idx="8">
                    <c:v>30</c:v>
                  </c:pt>
                  <c:pt idx="9">
                    <c:v>3</c:v>
                  </c:pt>
                  <c:pt idx="10">
                    <c:v>10</c:v>
                  </c:pt>
                  <c:pt idx="11">
                    <c:v>30</c:v>
                  </c:pt>
                  <c:pt idx="12">
                    <c:v>3</c:v>
                  </c:pt>
                  <c:pt idx="13">
                    <c:v>10</c:v>
                  </c:pt>
                  <c:pt idx="14">
                    <c:v>30</c:v>
                  </c:pt>
                </c:lvl>
                <c:lvl>
                  <c:pt idx="0">
                    <c:v>Std
(µg/mL) </c:v>
                  </c:pt>
                  <c:pt idx="3">
                    <c:v>NNFM
(µg/mL) </c:v>
                  </c:pt>
                  <c:pt idx="6">
                    <c:v>NNFH
(µg/mL) </c:v>
                  </c:pt>
                  <c:pt idx="9">
                    <c:v>NNFC
(µg/mL) </c:v>
                  </c:pt>
                  <c:pt idx="12">
                    <c:v>NNFW
(µg/mL) </c:v>
                  </c:pt>
                </c:lvl>
              </c:multiLvlStrCache>
            </c:multiLvlStrRef>
          </c:cat>
          <c:val>
            <c:numRef>
              <c:f>'HO radical (2)'!$L$8:$L$22</c:f>
              <c:numCache>
                <c:formatCode>0.00</c:formatCode>
                <c:ptCount val="15"/>
                <c:pt idx="0">
                  <c:v>46.55461282773831</c:v>
                </c:pt>
                <c:pt idx="1">
                  <c:v>62.758995621529664</c:v>
                </c:pt>
                <c:pt idx="2">
                  <c:v>79.523126495342765</c:v>
                </c:pt>
                <c:pt idx="3">
                  <c:v>10.561558331187104</c:v>
                </c:pt>
                <c:pt idx="4">
                  <c:v>47.253932557017229</c:v>
                </c:pt>
                <c:pt idx="5">
                  <c:v>57.755427581337152</c:v>
                </c:pt>
                <c:pt idx="6">
                  <c:v>12.542926337530334</c:v>
                </c:pt>
                <c:pt idx="7">
                  <c:v>36.51005455861138</c:v>
                </c:pt>
                <c:pt idx="8">
                  <c:v>54.554205419427284</c:v>
                </c:pt>
                <c:pt idx="9">
                  <c:v>8.8489406323741751</c:v>
                </c:pt>
                <c:pt idx="10">
                  <c:v>42.357492040454808</c:v>
                </c:pt>
                <c:pt idx="11">
                  <c:v>53.074559888227974</c:v>
                </c:pt>
                <c:pt idx="12">
                  <c:v>13.905778492581561</c:v>
                </c:pt>
                <c:pt idx="13">
                  <c:v>37.321276548678682</c:v>
                </c:pt>
                <c:pt idx="14">
                  <c:v>51.2078364044708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F-DBFA-4096-8A4E-F0D1816F76F2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50"/>
        <c:axId val="152620416"/>
        <c:axId val="152667264"/>
      </c:barChart>
      <c:lineChart>
        <c:grouping val="standard"/>
        <c:varyColors val="0"/>
        <c:ser>
          <c:idx val="1"/>
          <c:order val="1"/>
          <c:tx>
            <c:v>Superoxide radical</c:v>
          </c:tx>
          <c:spPr>
            <a:ln w="158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errBars>
            <c:errDir val="y"/>
            <c:errBarType val="both"/>
            <c:errValType val="cust"/>
            <c:noEndCap val="0"/>
            <c:plus>
              <c:numRef>
                <c:f>'HO radical (2)'!$G$27:$G$41</c:f>
                <c:numCache>
                  <c:formatCode>General</c:formatCode>
                  <c:ptCount val="15"/>
                  <c:pt idx="0">
                    <c:v>3.4422288600944198</c:v>
                  </c:pt>
                  <c:pt idx="1">
                    <c:v>2.0957695865021067</c:v>
                  </c:pt>
                  <c:pt idx="2">
                    <c:v>2.0487907885191659</c:v>
                  </c:pt>
                  <c:pt idx="3">
                    <c:v>3.6724319543218735</c:v>
                  </c:pt>
                  <c:pt idx="4">
                    <c:v>2.1728386645484221</c:v>
                  </c:pt>
                  <c:pt idx="5">
                    <c:v>0.44235708087465986</c:v>
                  </c:pt>
                  <c:pt idx="6">
                    <c:v>2.7028946505565319</c:v>
                  </c:pt>
                  <c:pt idx="7">
                    <c:v>2.0709061841016787</c:v>
                  </c:pt>
                  <c:pt idx="8">
                    <c:v>9.9098450214325062</c:v>
                  </c:pt>
                  <c:pt idx="9">
                    <c:v>5.3032413234256204</c:v>
                  </c:pt>
                  <c:pt idx="10">
                    <c:v>4.1987755104295976</c:v>
                  </c:pt>
                  <c:pt idx="11">
                    <c:v>2.0060484726123011</c:v>
                  </c:pt>
                  <c:pt idx="12">
                    <c:v>3.5885127349508474</c:v>
                  </c:pt>
                  <c:pt idx="13">
                    <c:v>2.8161296625422119</c:v>
                  </c:pt>
                  <c:pt idx="14">
                    <c:v>2.173766817869377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HO radical (2)'!$D$7:$E$22</c:f>
              <c:multiLvlStrCache>
                <c:ptCount val="16"/>
                <c:lvl>
                  <c:pt idx="1">
                    <c:v>0.3</c:v>
                  </c:pt>
                  <c:pt idx="2">
                    <c:v>1</c:v>
                  </c:pt>
                  <c:pt idx="3">
                    <c:v>3</c:v>
                  </c:pt>
                  <c:pt idx="4">
                    <c:v>3</c:v>
                  </c:pt>
                  <c:pt idx="5">
                    <c:v>10</c:v>
                  </c:pt>
                  <c:pt idx="6">
                    <c:v>30</c:v>
                  </c:pt>
                  <c:pt idx="7">
                    <c:v>3</c:v>
                  </c:pt>
                  <c:pt idx="8">
                    <c:v>10</c:v>
                  </c:pt>
                  <c:pt idx="9">
                    <c:v>30</c:v>
                  </c:pt>
                  <c:pt idx="10">
                    <c:v>3</c:v>
                  </c:pt>
                  <c:pt idx="11">
                    <c:v>10</c:v>
                  </c:pt>
                  <c:pt idx="12">
                    <c:v>30</c:v>
                  </c:pt>
                  <c:pt idx="13">
                    <c:v>3</c:v>
                  </c:pt>
                  <c:pt idx="14">
                    <c:v>10</c:v>
                  </c:pt>
                  <c:pt idx="15">
                    <c:v>30</c:v>
                  </c:pt>
                </c:lvl>
                <c:lvl>
                  <c:pt idx="0">
                    <c:v>Control </c:v>
                  </c:pt>
                  <c:pt idx="1">
                    <c:v>Std
(µg/mL) </c:v>
                  </c:pt>
                  <c:pt idx="4">
                    <c:v>NNFM
(µg/mL) </c:v>
                  </c:pt>
                  <c:pt idx="7">
                    <c:v>NNFH
(µg/mL) </c:v>
                  </c:pt>
                  <c:pt idx="10">
                    <c:v>NNFC
(µg/mL) </c:v>
                  </c:pt>
                  <c:pt idx="13">
                    <c:v>NNFW
(µg/mL) </c:v>
                  </c:pt>
                </c:lvl>
              </c:multiLvlStrCache>
            </c:multiLvlStrRef>
          </c:cat>
          <c:val>
            <c:numRef>
              <c:f>'HO radical (2)'!$F$27:$F$41</c:f>
              <c:numCache>
                <c:formatCode>General</c:formatCode>
                <c:ptCount val="15"/>
                <c:pt idx="0">
                  <c:v>25.181647787080738</c:v>
                </c:pt>
                <c:pt idx="1">
                  <c:v>49.742535221924804</c:v>
                </c:pt>
                <c:pt idx="2">
                  <c:v>77.599698571913521</c:v>
                </c:pt>
                <c:pt idx="3">
                  <c:v>44.27787299665988</c:v>
                </c:pt>
                <c:pt idx="4">
                  <c:v>74.343530594944653</c:v>
                </c:pt>
                <c:pt idx="5">
                  <c:v>85.661715968001246</c:v>
                </c:pt>
                <c:pt idx="6">
                  <c:v>8.4570217361119671</c:v>
                </c:pt>
                <c:pt idx="7">
                  <c:v>35.367761000150914</c:v>
                </c:pt>
                <c:pt idx="8">
                  <c:v>31.271522051531651</c:v>
                </c:pt>
                <c:pt idx="9">
                  <c:v>36.404892696512455</c:v>
                </c:pt>
                <c:pt idx="10">
                  <c:v>41.139900032697028</c:v>
                </c:pt>
                <c:pt idx="11">
                  <c:v>33.081246993431904</c:v>
                </c:pt>
                <c:pt idx="12">
                  <c:v>39.821801650744334</c:v>
                </c:pt>
                <c:pt idx="13">
                  <c:v>64.645849346078663</c:v>
                </c:pt>
                <c:pt idx="14">
                  <c:v>82.4705855690900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10-DBFA-4096-8A4E-F0D1816F76F2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marker val="1"/>
        <c:smooth val="0"/>
        <c:axId val="152674688"/>
        <c:axId val="152668800"/>
      </c:lineChart>
      <c:catAx>
        <c:axId val="152620416"/>
        <c:scaling>
          <c:orientation val="minMax"/>
        </c:scaling>
        <c:delete val="0"/>
        <c:axPos val="b"/>
        <c:numFmt formatCode="General" sourceLinked="1"/>
        <c:majorTickMark val="cross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2667264"/>
        <c:crosses val="autoZero"/>
        <c:auto val="1"/>
        <c:lblAlgn val="ctr"/>
        <c:lblOffset val="100"/>
        <c:noMultiLvlLbl val="0"/>
      </c:catAx>
      <c:valAx>
        <c:axId val="152667264"/>
        <c:scaling>
          <c:orientation val="minMax"/>
          <c:max val="100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2620416"/>
        <c:crosses val="autoZero"/>
        <c:crossBetween val="between"/>
        <c:majorUnit val="25"/>
      </c:valAx>
      <c:valAx>
        <c:axId val="152668800"/>
        <c:scaling>
          <c:orientation val="minMax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2674688"/>
        <c:crosses val="max"/>
        <c:crossBetween val="between"/>
        <c:majorUnit val="25"/>
      </c:valAx>
      <c:catAx>
        <c:axId val="152674688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52668800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35921107440738559"/>
          <c:y val="2.3726305045202706E-2"/>
          <c:w val="0.47382310895470958"/>
          <c:h val="8.386086000611164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6674898760017869E-2"/>
          <c:y val="0.12515517972530349"/>
          <c:w val="0.89886190386539233"/>
          <c:h val="0.60420718411770691"/>
        </c:manualLayout>
      </c:layout>
      <c:barChart>
        <c:barDir val="col"/>
        <c:grouping val="clustered"/>
        <c:varyColors val="0"/>
        <c:ser>
          <c:idx val="0"/>
          <c:order val="0"/>
          <c:tx>
            <c:v>CUPRAC </c:v>
          </c:tx>
          <c:spPr>
            <a:solidFill>
              <a:schemeClr val="bg1">
                <a:lumMod val="50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dLbls>
            <c:dLbl>
              <c:idx val="0"/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2812-4E23-96A6-7BB2EFF39BC9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2812-4E23-96A6-7BB2EFF39BC9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2812-4E23-96A6-7BB2EFF39BC9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2812-4E23-96A6-7BB2EFF39BC9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4-2812-4E23-96A6-7BB2EFF39BC9}"/>
                </c:ext>
              </c:extLst>
            </c:dLbl>
            <c:dLbl>
              <c:idx val="5"/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2812-4E23-96A6-7BB2EFF39BC9}"/>
                </c:ext>
              </c:extLst>
            </c:dLbl>
            <c:dLbl>
              <c:idx val="6"/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6-2812-4E23-96A6-7BB2EFF39BC9}"/>
                </c:ext>
              </c:extLst>
            </c:dLbl>
            <c:dLbl>
              <c:idx val="7"/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2812-4E23-96A6-7BB2EFF39BC9}"/>
                </c:ext>
              </c:extLst>
            </c:dLbl>
            <c:dLbl>
              <c:idx val="8"/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8-2812-4E23-96A6-7BB2EFF39BC9}"/>
                </c:ext>
              </c:extLst>
            </c:dLbl>
            <c:dLbl>
              <c:idx val="9"/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2812-4E23-96A6-7BB2EFF39BC9}"/>
                </c:ext>
              </c:extLst>
            </c:dLbl>
            <c:dLbl>
              <c:idx val="10"/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A-2812-4E23-96A6-7BB2EFF39BC9}"/>
                </c:ext>
              </c:extLst>
            </c:dLbl>
            <c:dLbl>
              <c:idx val="11"/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2812-4E23-96A6-7BB2EFF39BC9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plus"/>
            <c:errValType val="cust"/>
            <c:noEndCap val="0"/>
            <c:plus>
              <c:numRef>
                <c:f>'CUPRAC (2)'!$U$13:$U$24</c:f>
                <c:numCache>
                  <c:formatCode>General</c:formatCode>
                  <c:ptCount val="12"/>
                  <c:pt idx="0">
                    <c:v>0.81074690728853493</c:v>
                  </c:pt>
                  <c:pt idx="1">
                    <c:v>0.64271574557663935</c:v>
                  </c:pt>
                  <c:pt idx="2">
                    <c:v>0.62085912034567725</c:v>
                  </c:pt>
                  <c:pt idx="3">
                    <c:v>0.2643287857491774</c:v>
                  </c:pt>
                  <c:pt idx="4">
                    <c:v>1.1132023981267867</c:v>
                  </c:pt>
                  <c:pt idx="5">
                    <c:v>1.3045263485098575</c:v>
                  </c:pt>
                  <c:pt idx="6">
                    <c:v>0.93896368149957277</c:v>
                  </c:pt>
                  <c:pt idx="7">
                    <c:v>0.51376342345246573</c:v>
                  </c:pt>
                  <c:pt idx="8">
                    <c:v>0.64901761191916307</c:v>
                  </c:pt>
                  <c:pt idx="9">
                    <c:v>0.41972218726600807</c:v>
                  </c:pt>
                  <c:pt idx="10">
                    <c:v>0.70782167329708856</c:v>
                  </c:pt>
                  <c:pt idx="11">
                    <c:v>0.27281536589367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CUPRAC (2)'!$B$13:$C$24</c:f>
              <c:multiLvlStrCache>
                <c:ptCount val="12"/>
                <c:lvl>
                  <c:pt idx="0">
                    <c:v>3</c:v>
                  </c:pt>
                  <c:pt idx="1">
                    <c:v>10</c:v>
                  </c:pt>
                  <c:pt idx="2">
                    <c:v>30</c:v>
                  </c:pt>
                  <c:pt idx="3">
                    <c:v>3</c:v>
                  </c:pt>
                  <c:pt idx="4">
                    <c:v>10</c:v>
                  </c:pt>
                  <c:pt idx="5">
                    <c:v>30</c:v>
                  </c:pt>
                  <c:pt idx="6">
                    <c:v>3</c:v>
                  </c:pt>
                  <c:pt idx="7">
                    <c:v>10</c:v>
                  </c:pt>
                  <c:pt idx="8">
                    <c:v>30</c:v>
                  </c:pt>
                  <c:pt idx="9">
                    <c:v>3</c:v>
                  </c:pt>
                  <c:pt idx="10">
                    <c:v>10</c:v>
                  </c:pt>
                  <c:pt idx="11">
                    <c:v>30</c:v>
                  </c:pt>
                </c:lvl>
                <c:lvl>
                  <c:pt idx="0">
                    <c:v>NNFM
(µg/mL) </c:v>
                  </c:pt>
                  <c:pt idx="3">
                    <c:v>NNFH
(µg/mL) </c:v>
                  </c:pt>
                  <c:pt idx="6">
                    <c:v>NNFC
(µg/mL) </c:v>
                  </c:pt>
                  <c:pt idx="9">
                    <c:v>NNFW
(µg/mL) </c:v>
                  </c:pt>
                </c:lvl>
              </c:multiLvlStrCache>
            </c:multiLvlStrRef>
          </c:cat>
          <c:val>
            <c:numRef>
              <c:f>'CUPRAC (2)'!$Q$13:$Q$24</c:f>
              <c:numCache>
                <c:formatCode>0.00</c:formatCode>
                <c:ptCount val="12"/>
                <c:pt idx="0">
                  <c:v>20.726764896114418</c:v>
                </c:pt>
                <c:pt idx="1">
                  <c:v>32.605093612623712</c:v>
                </c:pt>
                <c:pt idx="2">
                  <c:v>37.053477602890212</c:v>
                </c:pt>
                <c:pt idx="3">
                  <c:v>8.0586167578038488</c:v>
                </c:pt>
                <c:pt idx="4">
                  <c:v>22.252077496769544</c:v>
                </c:pt>
                <c:pt idx="5">
                  <c:v>31.811532930883541</c:v>
                </c:pt>
                <c:pt idx="6">
                  <c:v>13.747919043172516</c:v>
                </c:pt>
                <c:pt idx="7">
                  <c:v>27.55492124370884</c:v>
                </c:pt>
                <c:pt idx="8">
                  <c:v>34.998585728827351</c:v>
                </c:pt>
                <c:pt idx="9">
                  <c:v>12.478319386755604</c:v>
                </c:pt>
                <c:pt idx="10">
                  <c:v>30.019722092094479</c:v>
                </c:pt>
                <c:pt idx="11">
                  <c:v>34.8911127129586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2812-4E23-96A6-7BB2EFF39BC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53556480"/>
        <c:axId val="153558016"/>
      </c:barChart>
      <c:lineChart>
        <c:grouping val="standard"/>
        <c:varyColors val="0"/>
        <c:ser>
          <c:idx val="1"/>
          <c:order val="1"/>
          <c:tx>
            <c:v>FRAP</c:v>
          </c:tx>
          <c:spPr>
            <a:ln w="158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CUPRAC (2)'!$Z$13:$Z$24</c:f>
                <c:numCache>
                  <c:formatCode>General</c:formatCode>
                  <c:ptCount val="12"/>
                  <c:pt idx="0">
                    <c:v>0.16666884826243156</c:v>
                  </c:pt>
                  <c:pt idx="1">
                    <c:v>5.9305577892045463E-2</c:v>
                  </c:pt>
                  <c:pt idx="2">
                    <c:v>2.0389029981966917E-2</c:v>
                  </c:pt>
                  <c:pt idx="3">
                    <c:v>0.10505762603668732</c:v>
                  </c:pt>
                  <c:pt idx="4">
                    <c:v>4.5968435131082515E-2</c:v>
                  </c:pt>
                  <c:pt idx="5">
                    <c:v>3.9260798414173917E-2</c:v>
                  </c:pt>
                  <c:pt idx="6">
                    <c:v>0.12235056045160768</c:v>
                  </c:pt>
                  <c:pt idx="7">
                    <c:v>7.2453478555582221E-2</c:v>
                  </c:pt>
                  <c:pt idx="8">
                    <c:v>3.858030205283642E-2</c:v>
                  </c:pt>
                  <c:pt idx="9">
                    <c:v>0.17985341089573909</c:v>
                  </c:pt>
                  <c:pt idx="10">
                    <c:v>6.5716148730042612E-2</c:v>
                  </c:pt>
                  <c:pt idx="11">
                    <c:v>1.8964602131334898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CUPRAC (2)'!$X$13:$X$24</c:f>
              <c:numCache>
                <c:formatCode>General</c:formatCode>
                <c:ptCount val="12"/>
                <c:pt idx="0">
                  <c:v>8.4085512329705097</c:v>
                </c:pt>
                <c:pt idx="1">
                  <c:v>28.678605451546854</c:v>
                </c:pt>
                <c:pt idx="2">
                  <c:v>64.950287296937105</c:v>
                </c:pt>
                <c:pt idx="3">
                  <c:v>1.812275047949014</c:v>
                </c:pt>
                <c:pt idx="4">
                  <c:v>8.415224128360812</c:v>
                </c:pt>
                <c:pt idx="5">
                  <c:v>23.35549036681147</c:v>
                </c:pt>
                <c:pt idx="6">
                  <c:v>6.7469229072071935</c:v>
                </c:pt>
                <c:pt idx="7">
                  <c:v>20.032150924715779</c:v>
                </c:pt>
                <c:pt idx="8">
                  <c:v>47.303738220209823</c:v>
                </c:pt>
                <c:pt idx="9">
                  <c:v>7.9905818281069827</c:v>
                </c:pt>
                <c:pt idx="10">
                  <c:v>21.004148832431493</c:v>
                </c:pt>
                <c:pt idx="11">
                  <c:v>55.82955183711837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D-2812-4E23-96A6-7BB2EFF39BC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53573632"/>
        <c:axId val="153572096"/>
      </c:lineChart>
      <c:catAx>
        <c:axId val="1535564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3558016"/>
        <c:crosses val="autoZero"/>
        <c:auto val="1"/>
        <c:lblAlgn val="ctr"/>
        <c:lblOffset val="100"/>
        <c:noMultiLvlLbl val="0"/>
      </c:catAx>
      <c:valAx>
        <c:axId val="153558016"/>
        <c:scaling>
          <c:orientation val="minMax"/>
          <c:max val="40"/>
          <c:min val="0"/>
        </c:scaling>
        <c:delete val="0"/>
        <c:axPos val="l"/>
        <c:numFmt formatCode="0" sourceLinked="0"/>
        <c:majorTickMark val="cross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3556480"/>
        <c:crosses val="autoZero"/>
        <c:crossBetween val="between"/>
        <c:majorUnit val="10"/>
      </c:valAx>
      <c:valAx>
        <c:axId val="153572096"/>
        <c:scaling>
          <c:orientation val="minMax"/>
          <c:max val="75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3573632"/>
        <c:crosses val="max"/>
        <c:crossBetween val="between"/>
        <c:majorUnit val="15"/>
      </c:valAx>
      <c:catAx>
        <c:axId val="153573632"/>
        <c:scaling>
          <c:orientation val="minMax"/>
        </c:scaling>
        <c:delete val="1"/>
        <c:axPos val="b"/>
        <c:majorTickMark val="out"/>
        <c:minorTickMark val="none"/>
        <c:tickLblPos val="nextTo"/>
        <c:crossAx val="153572096"/>
        <c:crosses val="autoZero"/>
        <c:auto val="1"/>
        <c:lblAlgn val="ctr"/>
        <c:lblOffset val="100"/>
        <c:noMultiLvlLbl val="0"/>
      </c:catAx>
      <c:spPr>
        <a:noFill/>
        <a:ln w="12700">
          <a:noFill/>
        </a:ln>
        <a:effectLst/>
      </c:spPr>
    </c:plotArea>
    <c:legend>
      <c:legendPos val="r"/>
      <c:layout>
        <c:manualLayout>
          <c:xMode val="edge"/>
          <c:yMode val="edge"/>
          <c:x val="0.43712120373139007"/>
          <c:y val="7.1166904848638021E-3"/>
          <c:w val="0.31721541136471865"/>
          <c:h val="6.998925846013019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7326177738324123E-2"/>
          <c:y val="5.0925925925925923E-2"/>
          <c:w val="0.9299202539416962"/>
          <c:h val="0.67951656380790226"/>
        </c:manualLayout>
      </c:layout>
      <c:barChart>
        <c:barDir val="col"/>
        <c:grouping val="clustered"/>
        <c:varyColors val="0"/>
        <c:ser>
          <c:idx val="0"/>
          <c:order val="0"/>
          <c:spPr>
            <a:noFill/>
            <a:ln w="12700">
              <a:solidFill>
                <a:schemeClr val="tx1"/>
              </a:solidFill>
            </a:ln>
            <a:effectLst/>
          </c:spPr>
          <c:invertIfNegative val="0"/>
          <c:dLbls>
            <c:dLbl>
              <c:idx val="0"/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8D97-4DFD-9F78-51577DE5849D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8D97-4DFD-9F78-51577DE5849D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8D97-4DFD-9F78-51577DE5849D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8D97-4DFD-9F78-51577DE5849D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4-8D97-4DFD-9F78-51577DE5849D}"/>
                </c:ext>
              </c:extLst>
            </c:dLbl>
            <c:dLbl>
              <c:idx val="5"/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8D97-4DFD-9F78-51577DE5849D}"/>
                </c:ext>
              </c:extLst>
            </c:dLbl>
            <c:dLbl>
              <c:idx val="6"/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6-8D97-4DFD-9F78-51577DE5849D}"/>
                </c:ext>
              </c:extLst>
            </c:dLbl>
            <c:dLbl>
              <c:idx val="7"/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8D97-4DFD-9F78-51577DE5849D}"/>
                </c:ext>
              </c:extLst>
            </c:dLbl>
            <c:dLbl>
              <c:idx val="8"/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8-8D97-4DFD-9F78-51577DE5849D}"/>
                </c:ext>
              </c:extLst>
            </c:dLbl>
            <c:dLbl>
              <c:idx val="9"/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8D97-4DFD-9F78-51577DE5849D}"/>
                </c:ext>
              </c:extLst>
            </c:dLbl>
            <c:dLbl>
              <c:idx val="10"/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A-8D97-4DFD-9F78-51577DE5849D}"/>
                </c:ext>
              </c:extLst>
            </c:dLbl>
            <c:dLbl>
              <c:idx val="11"/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8D97-4DFD-9F78-51577DE5849D}"/>
                </c:ext>
              </c:extLst>
            </c:dLbl>
            <c:dLbl>
              <c:idx val="12"/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C-8D97-4DFD-9F78-51577DE5849D}"/>
                </c:ext>
              </c:extLst>
            </c:dLbl>
            <c:dLbl>
              <c:idx val="13"/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D-8D97-4DFD-9F78-51577DE5849D}"/>
                </c:ext>
              </c:extLst>
            </c:dLbl>
            <c:dLbl>
              <c:idx val="14"/>
              <c:tx>
                <c:rich>
                  <a:bodyPr/>
                  <a:lstStyle/>
                  <a:p>
                    <a:r>
                      <a:rPr lang="en-US"/>
                      <a:t>**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E-8D97-4DFD-9F78-51577DE5849D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plus"/>
            <c:errValType val="cust"/>
            <c:noEndCap val="0"/>
            <c:plus>
              <c:numRef>
                <c:f>NNFE!$AL$108:$AL$119</c:f>
                <c:numCache>
                  <c:formatCode>General</c:formatCode>
                  <c:ptCount val="12"/>
                  <c:pt idx="0">
                    <c:v>2.4660540484599206E-2</c:v>
                  </c:pt>
                  <c:pt idx="1">
                    <c:v>1.6434638180484712E-2</c:v>
                  </c:pt>
                  <c:pt idx="2">
                    <c:v>4.0906566081232748E-2</c:v>
                  </c:pt>
                  <c:pt idx="3">
                    <c:v>2.6791329704462619E-2</c:v>
                  </c:pt>
                  <c:pt idx="4">
                    <c:v>4.8918466699929532E-2</c:v>
                  </c:pt>
                  <c:pt idx="5">
                    <c:v>1.3184572820939249E-2</c:v>
                  </c:pt>
                  <c:pt idx="6">
                    <c:v>5.9635106205079821E-2</c:v>
                  </c:pt>
                  <c:pt idx="7">
                    <c:v>2.6835885406316859E-2</c:v>
                  </c:pt>
                  <c:pt idx="8">
                    <c:v>7.0764396538848312E-3</c:v>
                  </c:pt>
                  <c:pt idx="9">
                    <c:v>2.8051690647791661E-2</c:v>
                  </c:pt>
                  <c:pt idx="10">
                    <c:v>5.5793464458230774E-2</c:v>
                  </c:pt>
                  <c:pt idx="11">
                    <c:v>2.713484505539681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NNFE!$B$108:$C$119</c:f>
              <c:multiLvlStrCache>
                <c:ptCount val="12"/>
                <c:lvl>
                  <c:pt idx="0">
                    <c:v>1</c:v>
                  </c:pt>
                  <c:pt idx="1">
                    <c:v>3</c:v>
                  </c:pt>
                  <c:pt idx="2">
                    <c:v>10</c:v>
                  </c:pt>
                  <c:pt idx="3">
                    <c:v>1</c:v>
                  </c:pt>
                  <c:pt idx="4">
                    <c:v>3</c:v>
                  </c:pt>
                  <c:pt idx="5">
                    <c:v>10</c:v>
                  </c:pt>
                  <c:pt idx="6">
                    <c:v>1</c:v>
                  </c:pt>
                  <c:pt idx="7">
                    <c:v>3</c:v>
                  </c:pt>
                  <c:pt idx="8">
                    <c:v>10</c:v>
                  </c:pt>
                  <c:pt idx="9">
                    <c:v>1</c:v>
                  </c:pt>
                  <c:pt idx="10">
                    <c:v>3</c:v>
                  </c:pt>
                  <c:pt idx="11">
                    <c:v>10</c:v>
                  </c:pt>
                </c:lvl>
                <c:lvl>
                  <c:pt idx="0">
                    <c:v>NNFM
(µg/mL)</c:v>
                  </c:pt>
                  <c:pt idx="3">
                    <c:v>NNFH
(µg/mL)</c:v>
                  </c:pt>
                  <c:pt idx="6">
                    <c:v>NNFC
(µg/mL)</c:v>
                  </c:pt>
                  <c:pt idx="9">
                    <c:v>NNFW
(µg/mL)</c:v>
                  </c:pt>
                </c:lvl>
              </c:multiLvlStrCache>
            </c:multiLvlStrRef>
          </c:cat>
          <c:val>
            <c:numRef>
              <c:f>NNFE!$AK$108:$AK$119</c:f>
              <c:numCache>
                <c:formatCode>0.00</c:formatCode>
                <c:ptCount val="12"/>
                <c:pt idx="0">
                  <c:v>1.6574667652032824</c:v>
                </c:pt>
                <c:pt idx="1">
                  <c:v>3.6755191903841906</c:v>
                </c:pt>
                <c:pt idx="2">
                  <c:v>8.14081259905217</c:v>
                </c:pt>
                <c:pt idx="3">
                  <c:v>0.80135719118490034</c:v>
                </c:pt>
                <c:pt idx="4">
                  <c:v>2.2369372146645055</c:v>
                </c:pt>
                <c:pt idx="5">
                  <c:v>4.9502157629508323</c:v>
                </c:pt>
                <c:pt idx="6">
                  <c:v>1.9423030689920693</c:v>
                </c:pt>
                <c:pt idx="7">
                  <c:v>3.6801548620221807</c:v>
                </c:pt>
                <c:pt idx="8">
                  <c:v>8.8777827825608302</c:v>
                </c:pt>
                <c:pt idx="9">
                  <c:v>1.0534940492470086</c:v>
                </c:pt>
                <c:pt idx="10">
                  <c:v>1.7393512254457963</c:v>
                </c:pt>
                <c:pt idx="11">
                  <c:v>4.900396780517658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F-8D97-4DFD-9F78-51577DE5849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53630208"/>
        <c:axId val="153631744"/>
      </c:barChart>
      <c:catAx>
        <c:axId val="1536302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3631744"/>
        <c:crosses val="autoZero"/>
        <c:auto val="1"/>
        <c:lblAlgn val="ctr"/>
        <c:lblOffset val="100"/>
        <c:noMultiLvlLbl val="0"/>
      </c:catAx>
      <c:valAx>
        <c:axId val="153631744"/>
        <c:scaling>
          <c:orientation val="minMax"/>
          <c:max val="10"/>
          <c:min val="0"/>
        </c:scaling>
        <c:delete val="0"/>
        <c:axPos val="l"/>
        <c:numFmt formatCode="0" sourceLinked="0"/>
        <c:majorTickMark val="cross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3630208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822513444560689"/>
          <c:y val="6.4798033113686135E-2"/>
          <c:w val="0.88444156892975789"/>
          <c:h val="0.5676196678512172"/>
        </c:manualLayout>
      </c:layout>
      <c:barChart>
        <c:barDir val="col"/>
        <c:grouping val="clustered"/>
        <c:varyColors val="0"/>
        <c:ser>
          <c:idx val="0"/>
          <c:order val="0"/>
          <c:tx>
            <c:v>DPPH</c:v>
          </c:tx>
          <c:spPr>
            <a:solidFill>
              <a:schemeClr val="bg1">
                <a:lumMod val="50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DPPH std'!$N$48:$N$56</c:f>
                <c:numCache>
                  <c:formatCode>General</c:formatCode>
                  <c:ptCount val="9"/>
                  <c:pt idx="0">
                    <c:v>1.9566631631245586</c:v>
                  </c:pt>
                  <c:pt idx="1">
                    <c:v>1.4588924165402017</c:v>
                  </c:pt>
                  <c:pt idx="2">
                    <c:v>0.77975762117290803</c:v>
                  </c:pt>
                  <c:pt idx="3">
                    <c:v>0.71564281087292769</c:v>
                  </c:pt>
                  <c:pt idx="4">
                    <c:v>8.7981326751655264E-2</c:v>
                  </c:pt>
                  <c:pt idx="5">
                    <c:v>1.9980417514931228</c:v>
                  </c:pt>
                  <c:pt idx="6">
                    <c:v>2.681611457995885</c:v>
                  </c:pt>
                  <c:pt idx="7">
                    <c:v>2.0090292975496742</c:v>
                  </c:pt>
                  <c:pt idx="8">
                    <c:v>1.684263362375610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DPPH std'!$D$48:$E$56</c:f>
              <c:strCache>
                <c:ptCount val="9"/>
                <c:pt idx="0">
                  <c:v>Galic acid</c:v>
                </c:pt>
                <c:pt idx="1">
                  <c:v>Catechin</c:v>
                </c:pt>
                <c:pt idx="2">
                  <c:v>Epigallo catechin</c:v>
                </c:pt>
                <c:pt idx="3">
                  <c:v>Epicatechin gallate</c:v>
                </c:pt>
                <c:pt idx="4">
                  <c:v>Apigenin</c:v>
                </c:pt>
                <c:pt idx="5">
                  <c:v>Caffeic acid</c:v>
                </c:pt>
                <c:pt idx="6">
                  <c:v>Epicatechin</c:v>
                </c:pt>
                <c:pt idx="7">
                  <c:v>Quercetin</c:v>
                </c:pt>
                <c:pt idx="8">
                  <c:v>NNFE</c:v>
                </c:pt>
              </c:strCache>
            </c:strRef>
          </c:cat>
          <c:val>
            <c:numRef>
              <c:f>'DPPH std'!$M$48:$M$56</c:f>
              <c:numCache>
                <c:formatCode>General</c:formatCode>
                <c:ptCount val="9"/>
                <c:pt idx="0">
                  <c:v>29.81534657144444</c:v>
                </c:pt>
                <c:pt idx="1">
                  <c:v>29.205848080161065</c:v>
                </c:pt>
                <c:pt idx="2">
                  <c:v>35.521424498785613</c:v>
                </c:pt>
                <c:pt idx="3">
                  <c:v>25.847183868964521</c:v>
                </c:pt>
                <c:pt idx="4">
                  <c:v>22.151656790708827</c:v>
                </c:pt>
                <c:pt idx="5">
                  <c:v>47.158091110976819</c:v>
                </c:pt>
                <c:pt idx="6">
                  <c:v>32.800624204308619</c:v>
                </c:pt>
                <c:pt idx="7">
                  <c:v>16.328803594353513</c:v>
                </c:pt>
                <c:pt idx="8">
                  <c:v>47.4185550255870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445-461F-A8C9-4A5230FF96BA}"/>
            </c:ext>
          </c:extLst>
        </c:ser>
        <c:ser>
          <c:idx val="1"/>
          <c:order val="1"/>
          <c:tx>
            <c:v>ABTS</c:v>
          </c:tx>
          <c:spPr>
            <a:pattFill prst="wdDnDiag">
              <a:fgClr>
                <a:schemeClr val="tx1"/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DPPH std'!$O$59:$O$67</c:f>
                <c:numCache>
                  <c:formatCode>General</c:formatCode>
                  <c:ptCount val="9"/>
                  <c:pt idx="0">
                    <c:v>0.11457143932138709</c:v>
                  </c:pt>
                  <c:pt idx="1">
                    <c:v>4.985316789574782E-2</c:v>
                  </c:pt>
                  <c:pt idx="2">
                    <c:v>3.4976971512646969E-2</c:v>
                  </c:pt>
                  <c:pt idx="3">
                    <c:v>2.6100466352892159E-2</c:v>
                  </c:pt>
                  <c:pt idx="4">
                    <c:v>4.5079712494476773E-2</c:v>
                  </c:pt>
                  <c:pt idx="5">
                    <c:v>2.5417880325992667E-2</c:v>
                  </c:pt>
                  <c:pt idx="6">
                    <c:v>2.4662217266898094E-2</c:v>
                  </c:pt>
                  <c:pt idx="7">
                    <c:v>4.1200411675668756E-2</c:v>
                  </c:pt>
                  <c:pt idx="8">
                    <c:v>3.6260691964817793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DPPH std'!$M$59:$M$67</c:f>
              <c:numCache>
                <c:formatCode>General</c:formatCode>
                <c:ptCount val="9"/>
                <c:pt idx="0">
                  <c:v>26.767946396624723</c:v>
                </c:pt>
                <c:pt idx="1">
                  <c:v>30.771460388400111</c:v>
                </c:pt>
                <c:pt idx="2">
                  <c:v>41.304585386809563</c:v>
                </c:pt>
                <c:pt idx="3">
                  <c:v>25.999958275951752</c:v>
                </c:pt>
                <c:pt idx="4">
                  <c:v>16.84489865343847</c:v>
                </c:pt>
                <c:pt idx="5">
                  <c:v>53.198976187849318</c:v>
                </c:pt>
                <c:pt idx="6">
                  <c:v>36.086317725463601</c:v>
                </c:pt>
                <c:pt idx="7">
                  <c:v>21.720665638235758</c:v>
                </c:pt>
                <c:pt idx="8">
                  <c:v>54.0723177605752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445-461F-A8C9-4A5230FF96BA}"/>
            </c:ext>
          </c:extLst>
        </c:ser>
        <c:ser>
          <c:idx val="2"/>
          <c:order val="2"/>
          <c:tx>
            <c:v>Superoxide</c:v>
          </c:tx>
          <c:spPr>
            <a:pattFill prst="pct75">
              <a:fgClr>
                <a:schemeClr val="tx1"/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DPPH std'!$O$69:$O$77</c:f>
                <c:numCache>
                  <c:formatCode>General</c:formatCode>
                  <c:ptCount val="9"/>
                  <c:pt idx="0">
                    <c:v>0.11703941480354196</c:v>
                  </c:pt>
                  <c:pt idx="1">
                    <c:v>0.13669593384831752</c:v>
                  </c:pt>
                  <c:pt idx="2">
                    <c:v>0.12050037796131492</c:v>
                  </c:pt>
                  <c:pt idx="3">
                    <c:v>0.11137239558059124</c:v>
                  </c:pt>
                  <c:pt idx="4">
                    <c:v>0.25225638524196065</c:v>
                  </c:pt>
                  <c:pt idx="5">
                    <c:v>2.761292526514799E-2</c:v>
                  </c:pt>
                  <c:pt idx="6">
                    <c:v>1.9394561571063222E-2</c:v>
                  </c:pt>
                  <c:pt idx="7">
                    <c:v>0.26063814516013567</c:v>
                  </c:pt>
                  <c:pt idx="8">
                    <c:v>5.3796999947541169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DPPH std'!$M$69:$M$77</c:f>
              <c:numCache>
                <c:formatCode>General</c:formatCode>
                <c:ptCount val="9"/>
                <c:pt idx="0">
                  <c:v>33.287245486905576</c:v>
                </c:pt>
                <c:pt idx="1">
                  <c:v>25.181647787080738</c:v>
                </c:pt>
                <c:pt idx="2">
                  <c:v>34.544875553293473</c:v>
                </c:pt>
                <c:pt idx="3">
                  <c:v>19.609213954695662</c:v>
                </c:pt>
                <c:pt idx="4">
                  <c:v>4.8531492770550342</c:v>
                </c:pt>
                <c:pt idx="5">
                  <c:v>48.99969155969</c:v>
                </c:pt>
                <c:pt idx="6">
                  <c:v>33.87813412147586</c:v>
                </c:pt>
                <c:pt idx="7">
                  <c:v>7.2484164665929987</c:v>
                </c:pt>
                <c:pt idx="8">
                  <c:v>50.2147768913264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445-461F-A8C9-4A5230FF96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53473024"/>
        <c:axId val="153474560"/>
      </c:barChart>
      <c:catAx>
        <c:axId val="1534730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3474560"/>
        <c:crosses val="autoZero"/>
        <c:auto val="1"/>
        <c:lblAlgn val="ctr"/>
        <c:lblOffset val="100"/>
        <c:noMultiLvlLbl val="0"/>
      </c:catAx>
      <c:valAx>
        <c:axId val="153474560"/>
        <c:scaling>
          <c:orientation val="minMax"/>
          <c:max val="6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b="1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adical Scavenging Activity </a:t>
                </a:r>
              </a:p>
              <a:p>
                <a:pPr>
                  <a:defRPr b="1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b="1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% Inhibition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0" sourceLinked="0"/>
        <c:majorTickMark val="cross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3473024"/>
        <c:crosses val="autoZero"/>
        <c:crossBetween val="between"/>
        <c:majorUnit val="20"/>
      </c:valAx>
      <c:spPr>
        <a:noFill/>
        <a:ln w="12700">
          <a:noFill/>
        </a:ln>
        <a:effectLst/>
      </c:spPr>
    </c:plotArea>
    <c:legend>
      <c:legendPos val="r"/>
      <c:layout>
        <c:manualLayout>
          <c:xMode val="edge"/>
          <c:yMode val="edge"/>
          <c:x val="0.1909332063029488"/>
          <c:y val="3.4996221557325506E-2"/>
          <c:w val="0.75449977115849842"/>
          <c:h val="7.6306833397602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441930845600821"/>
          <c:y val="8.3841953099903624E-2"/>
          <c:w val="0.8727078854273651"/>
          <c:h val="0.66102169432367452"/>
        </c:manualLayout>
      </c:layout>
      <c:barChart>
        <c:barDir val="col"/>
        <c:grouping val="clustered"/>
        <c:varyColors val="0"/>
        <c:ser>
          <c:idx val="0"/>
          <c:order val="0"/>
          <c:tx>
            <c:v>BV2 </c:v>
          </c:tx>
          <c:spPr>
            <a:solidFill>
              <a:schemeClr val="bg1">
                <a:lumMod val="50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MTT NNFE (BV2) '!$L$7:$L$13</c:f>
                <c:numCache>
                  <c:formatCode>General</c:formatCode>
                  <c:ptCount val="7"/>
                  <c:pt idx="0">
                    <c:v>5.196962766709632E-2</c:v>
                  </c:pt>
                  <c:pt idx="1">
                    <c:v>5.196962766709632E-2</c:v>
                  </c:pt>
                  <c:pt idx="2">
                    <c:v>5.1150882709766116E-2</c:v>
                  </c:pt>
                  <c:pt idx="3">
                    <c:v>2.7292886796422368E-2</c:v>
                  </c:pt>
                  <c:pt idx="4">
                    <c:v>1.1778207571906294E-2</c:v>
                  </c:pt>
                  <c:pt idx="5">
                    <c:v>4.1375065035597201E-2</c:v>
                  </c:pt>
                  <c:pt idx="6">
                    <c:v>1.3809785653682226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MTT NNFE (BV2) '!$D$7:$E$13</c:f>
              <c:multiLvlStrCache>
                <c:ptCount val="7"/>
                <c:lvl>
                  <c:pt idx="1">
                    <c:v>1</c:v>
                  </c:pt>
                  <c:pt idx="2">
                    <c:v>3</c:v>
                  </c:pt>
                  <c:pt idx="3">
                    <c:v>10</c:v>
                  </c:pt>
                  <c:pt idx="4">
                    <c:v>30</c:v>
                  </c:pt>
                  <c:pt idx="5">
                    <c:v>50</c:v>
                  </c:pt>
                  <c:pt idx="6">
                    <c:v>100</c:v>
                  </c:pt>
                </c:lvl>
                <c:lvl>
                  <c:pt idx="0">
                    <c:v>NT</c:v>
                  </c:pt>
                  <c:pt idx="1">
                    <c:v>NNFE
(µg/mL)  </c:v>
                  </c:pt>
                </c:lvl>
              </c:multiLvlStrCache>
            </c:multiLvlStrRef>
          </c:cat>
          <c:val>
            <c:numRef>
              <c:f>'MTT NNFE (BV2) '!$J$7:$J$13</c:f>
              <c:numCache>
                <c:formatCode>0.00%</c:formatCode>
                <c:ptCount val="7"/>
                <c:pt idx="0">
                  <c:v>1</c:v>
                </c:pt>
                <c:pt idx="1">
                  <c:v>1</c:v>
                </c:pt>
                <c:pt idx="2">
                  <c:v>1.0662041627770127</c:v>
                </c:pt>
                <c:pt idx="3">
                  <c:v>1.0325009599772879</c:v>
                </c:pt>
                <c:pt idx="4">
                  <c:v>1.0099194212625431</c:v>
                </c:pt>
                <c:pt idx="5">
                  <c:v>0.89036907097106743</c:v>
                </c:pt>
                <c:pt idx="6">
                  <c:v>0.682640630565827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DFA-4FF6-A23A-A76741702989}"/>
            </c:ext>
          </c:extLst>
        </c:ser>
        <c:ser>
          <c:idx val="1"/>
          <c:order val="1"/>
          <c:tx>
            <c:v>Raw 264.7</c:v>
          </c:tx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MTT NNFE (BV2) '!$R$7:$R$13</c:f>
                <c:numCache>
                  <c:formatCode>General</c:formatCode>
                  <c:ptCount val="7"/>
                  <c:pt idx="0">
                    <c:v>1.6977582033545484E-2</c:v>
                  </c:pt>
                  <c:pt idx="1">
                    <c:v>2.8417640619636298E-2</c:v>
                  </c:pt>
                  <c:pt idx="2">
                    <c:v>2.8417640619636298E-2</c:v>
                  </c:pt>
                  <c:pt idx="3">
                    <c:v>6.5787315328434376E-2</c:v>
                  </c:pt>
                  <c:pt idx="4">
                    <c:v>2.0306803341516865E-2</c:v>
                  </c:pt>
                  <c:pt idx="5">
                    <c:v>7.2652537084544513E-2</c:v>
                  </c:pt>
                  <c:pt idx="6">
                    <c:v>4.4007806167621698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MTT NNFE (BV2) '!$P$7:$P$13</c:f>
              <c:numCache>
                <c:formatCode>General</c:formatCode>
                <c:ptCount val="7"/>
                <c:pt idx="0">
                  <c:v>1</c:v>
                </c:pt>
                <c:pt idx="1">
                  <c:v>0.96763900646571854</c:v>
                </c:pt>
                <c:pt idx="2">
                  <c:v>1.0093497287249971</c:v>
                </c:pt>
                <c:pt idx="3">
                  <c:v>1.0098225629624511</c:v>
                </c:pt>
                <c:pt idx="4">
                  <c:v>0.93231644767310429</c:v>
                </c:pt>
                <c:pt idx="5">
                  <c:v>0.84163774956739257</c:v>
                </c:pt>
                <c:pt idx="6">
                  <c:v>0.414085252968536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DFA-4FF6-A23A-A7674170298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10"/>
        <c:axId val="153519232"/>
        <c:axId val="153520768"/>
      </c:barChart>
      <c:catAx>
        <c:axId val="1535192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3520768"/>
        <c:crosses val="autoZero"/>
        <c:auto val="1"/>
        <c:lblAlgn val="ctr"/>
        <c:lblOffset val="100"/>
        <c:noMultiLvlLbl val="0"/>
      </c:catAx>
      <c:valAx>
        <c:axId val="153520768"/>
        <c:scaling>
          <c:orientation val="minMax"/>
          <c:max val="1.2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200" b="1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ell Viability (% of Control)</a:t>
                </a:r>
              </a:p>
            </c:rich>
          </c:tx>
          <c:layout>
            <c:manualLayout>
              <c:xMode val="edge"/>
              <c:yMode val="edge"/>
              <c:x val="1.2173836502144552E-2"/>
              <c:y val="9.0543287457134497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0"/>
        <c:majorTickMark val="cross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3519232"/>
        <c:crosses val="autoZero"/>
        <c:crossBetween val="between"/>
        <c:majorUnit val="0.30000000000000004"/>
      </c:valAx>
      <c:spPr>
        <a:noFill/>
        <a:ln w="12700">
          <a:noFill/>
        </a:ln>
        <a:effectLst/>
      </c:spPr>
    </c:plotArea>
    <c:legend>
      <c:legendPos val="r"/>
      <c:layout>
        <c:manualLayout>
          <c:xMode val="edge"/>
          <c:yMode val="edge"/>
          <c:x val="0.56288281800140827"/>
          <c:y val="8.7423063247350839E-4"/>
          <c:w val="0.24402775110428271"/>
          <c:h val="8.074913113426472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441930845600821"/>
          <c:y val="5.0925925925925923E-2"/>
          <c:w val="0.8727078854273651"/>
          <c:h val="0.6896111036967836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MTT t-BHP'!$F$6</c:f>
              <c:strCache>
                <c:ptCount val="1"/>
                <c:pt idx="0">
                  <c:v>3 h</c:v>
                </c:pt>
              </c:strCache>
            </c:strRef>
          </c:tx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MTT t-BHP'!$K$7:$K$13</c:f>
                <c:numCache>
                  <c:formatCode>General</c:formatCode>
                  <c:ptCount val="7"/>
                  <c:pt idx="0">
                    <c:v>2.0037005205928181E-2</c:v>
                  </c:pt>
                  <c:pt idx="1">
                    <c:v>9.1915115177693841E-3</c:v>
                  </c:pt>
                  <c:pt idx="2">
                    <c:v>1.9704004718366912E-2</c:v>
                  </c:pt>
                  <c:pt idx="3">
                    <c:v>2.1727011530404024E-2</c:v>
                  </c:pt>
                  <c:pt idx="4">
                    <c:v>1.4334642909987799E-2</c:v>
                  </c:pt>
                  <c:pt idx="5">
                    <c:v>1.4879160787571084E-2</c:v>
                  </c:pt>
                  <c:pt idx="6">
                    <c:v>1.3406989923845718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'MTT t-BHP'!$D$7:$E$13</c:f>
              <c:multiLvlStrCache>
                <c:ptCount val="7"/>
                <c:lvl>
                  <c:pt idx="0">
                    <c:v>0</c:v>
                  </c:pt>
                  <c:pt idx="1">
                    <c:v>25</c:v>
                  </c:pt>
                  <c:pt idx="2">
                    <c:v>50</c:v>
                  </c:pt>
                  <c:pt idx="3">
                    <c:v>100</c:v>
                  </c:pt>
                  <c:pt idx="4">
                    <c:v>200</c:v>
                  </c:pt>
                  <c:pt idx="5">
                    <c:v>300</c:v>
                  </c:pt>
                  <c:pt idx="6">
                    <c:v>400</c:v>
                  </c:pt>
                </c:lvl>
                <c:lvl>
                  <c:pt idx="0">
                    <c:v>t-BHP
(µM)  </c:v>
                  </c:pt>
                </c:lvl>
              </c:multiLvlStrCache>
            </c:multiLvlStrRef>
          </c:cat>
          <c:val>
            <c:numRef>
              <c:f>'MTT t-BHP'!$F$7:$F$13</c:f>
              <c:numCache>
                <c:formatCode>0%</c:formatCode>
                <c:ptCount val="7"/>
                <c:pt idx="0">
                  <c:v>1</c:v>
                </c:pt>
                <c:pt idx="1">
                  <c:v>0.96379709328274432</c:v>
                </c:pt>
                <c:pt idx="2">
                  <c:v>0.95859971274056499</c:v>
                </c:pt>
                <c:pt idx="3">
                  <c:v>0.93296687937744471</c:v>
                </c:pt>
                <c:pt idx="4">
                  <c:v>0.92406151278266768</c:v>
                </c:pt>
                <c:pt idx="5">
                  <c:v>0.83722084052321766</c:v>
                </c:pt>
                <c:pt idx="6">
                  <c:v>0.804606337983968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8B1-4CC4-9D9F-5E514D46907A}"/>
            </c:ext>
          </c:extLst>
        </c:ser>
        <c:ser>
          <c:idx val="1"/>
          <c:order val="1"/>
          <c:tx>
            <c:strRef>
              <c:f>'MTT t-BHP'!$G$6</c:f>
              <c:strCache>
                <c:ptCount val="1"/>
                <c:pt idx="0">
                  <c:v>6 h</c:v>
                </c:pt>
              </c:strCache>
            </c:strRef>
          </c:tx>
          <c:spPr>
            <a:pattFill prst="pct20">
              <a:fgClr>
                <a:schemeClr val="tx1"/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MTT t-BHP'!$L$7:$L$13</c:f>
                <c:numCache>
                  <c:formatCode>General</c:formatCode>
                  <c:ptCount val="7"/>
                  <c:pt idx="0">
                    <c:v>1.2788518457578413E-2</c:v>
                  </c:pt>
                  <c:pt idx="1">
                    <c:v>1.2492003165606998E-2</c:v>
                  </c:pt>
                  <c:pt idx="2">
                    <c:v>1.1568089235890143E-2</c:v>
                  </c:pt>
                  <c:pt idx="3">
                    <c:v>2.1294359263988007E-2</c:v>
                  </c:pt>
                  <c:pt idx="4">
                    <c:v>2.1566595427101817E-2</c:v>
                  </c:pt>
                  <c:pt idx="5">
                    <c:v>2.5338810906906872E-2</c:v>
                  </c:pt>
                  <c:pt idx="6">
                    <c:v>2.1625426495014696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MTT t-BHP'!$G$7:$G$13</c:f>
              <c:numCache>
                <c:formatCode>0%</c:formatCode>
                <c:ptCount val="7"/>
                <c:pt idx="0">
                  <c:v>1</c:v>
                </c:pt>
                <c:pt idx="1">
                  <c:v>0.97986510814920902</c:v>
                </c:pt>
                <c:pt idx="2">
                  <c:v>0.93003491940916605</c:v>
                </c:pt>
                <c:pt idx="3">
                  <c:v>0.87138895171295738</c:v>
                </c:pt>
                <c:pt idx="4">
                  <c:v>0.62672433484034862</c:v>
                </c:pt>
                <c:pt idx="5">
                  <c:v>0.54382310236279285</c:v>
                </c:pt>
                <c:pt idx="6">
                  <c:v>0.364239123703373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8B1-4CC4-9D9F-5E514D46907A}"/>
            </c:ext>
          </c:extLst>
        </c:ser>
        <c:ser>
          <c:idx val="2"/>
          <c:order val="2"/>
          <c:tx>
            <c:strRef>
              <c:f>'MTT t-BHP'!$H$6</c:f>
              <c:strCache>
                <c:ptCount val="1"/>
                <c:pt idx="0">
                  <c:v>12 h</c:v>
                </c:pt>
              </c:strCache>
            </c:strRef>
          </c:tx>
          <c:spPr>
            <a:pattFill prst="pct60">
              <a:fgClr>
                <a:schemeClr val="tx1"/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MTT t-BHP'!$M$7:$M$13</c:f>
                <c:numCache>
                  <c:formatCode>General</c:formatCode>
                  <c:ptCount val="7"/>
                  <c:pt idx="0">
                    <c:v>2.0661855560094845E-2</c:v>
                  </c:pt>
                  <c:pt idx="1">
                    <c:v>6.3951128935425799E-3</c:v>
                  </c:pt>
                  <c:pt idx="2">
                    <c:v>2.9964382236965473E-2</c:v>
                  </c:pt>
                  <c:pt idx="3">
                    <c:v>3.0104398424276424E-2</c:v>
                  </c:pt>
                  <c:pt idx="4">
                    <c:v>2.1239288909001015E-2</c:v>
                  </c:pt>
                  <c:pt idx="5">
                    <c:v>9.8406133967364005E-3</c:v>
                  </c:pt>
                  <c:pt idx="6">
                    <c:v>8.6222787818938194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MTT t-BHP'!$H$7:$H$13</c:f>
              <c:numCache>
                <c:formatCode>0%</c:formatCode>
                <c:ptCount val="7"/>
                <c:pt idx="0">
                  <c:v>1</c:v>
                </c:pt>
                <c:pt idx="1">
                  <c:v>0.98798327565531252</c:v>
                </c:pt>
                <c:pt idx="2">
                  <c:v>0.8475085327173979</c:v>
                </c:pt>
                <c:pt idx="3">
                  <c:v>0.69205940165718982</c:v>
                </c:pt>
                <c:pt idx="4">
                  <c:v>0.39188857766872726</c:v>
                </c:pt>
                <c:pt idx="5">
                  <c:v>0.339866203066441</c:v>
                </c:pt>
                <c:pt idx="6">
                  <c:v>0.204284902450680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8B1-4CC4-9D9F-5E514D46907A}"/>
            </c:ext>
          </c:extLst>
        </c:ser>
        <c:ser>
          <c:idx val="3"/>
          <c:order val="3"/>
          <c:tx>
            <c:strRef>
              <c:f>'MTT t-BHP'!$I$6</c:f>
              <c:strCache>
                <c:ptCount val="1"/>
                <c:pt idx="0">
                  <c:v>24 h</c:v>
                </c:pt>
              </c:strCache>
            </c:strRef>
          </c:tx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MTT t-BHP'!$N$7:$N$13</c:f>
                <c:numCache>
                  <c:formatCode>General</c:formatCode>
                  <c:ptCount val="7"/>
                  <c:pt idx="0">
                    <c:v>2.0557007577270161E-2</c:v>
                  </c:pt>
                  <c:pt idx="1">
                    <c:v>1.6416807724078313E-2</c:v>
                  </c:pt>
                  <c:pt idx="2">
                    <c:v>5.3324855016688225E-3</c:v>
                  </c:pt>
                  <c:pt idx="3">
                    <c:v>2.8121507852178991E-2</c:v>
                  </c:pt>
                  <c:pt idx="4">
                    <c:v>1.5379524465363215E-2</c:v>
                  </c:pt>
                  <c:pt idx="5">
                    <c:v>2.0532626427897587E-2</c:v>
                  </c:pt>
                  <c:pt idx="6">
                    <c:v>7.7516448195643108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'MTT t-BHP'!$I$7:$I$13</c:f>
              <c:numCache>
                <c:formatCode>0%</c:formatCode>
                <c:ptCount val="7"/>
                <c:pt idx="0">
                  <c:v>1</c:v>
                </c:pt>
                <c:pt idx="1">
                  <c:v>0.84465319647621184</c:v>
                </c:pt>
                <c:pt idx="2">
                  <c:v>0.80628464975763514</c:v>
                </c:pt>
                <c:pt idx="3">
                  <c:v>0.60130692887490877</c:v>
                </c:pt>
                <c:pt idx="4">
                  <c:v>0.36443574194353351</c:v>
                </c:pt>
                <c:pt idx="5">
                  <c:v>0.33169938458300047</c:v>
                </c:pt>
                <c:pt idx="6">
                  <c:v>0.186280544265701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8B1-4CC4-9D9F-5E514D46907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52998656"/>
        <c:axId val="153000192"/>
      </c:barChart>
      <c:catAx>
        <c:axId val="1529986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3000192"/>
        <c:crosses val="autoZero"/>
        <c:auto val="1"/>
        <c:lblAlgn val="ctr"/>
        <c:lblOffset val="100"/>
        <c:noMultiLvlLbl val="0"/>
      </c:catAx>
      <c:valAx>
        <c:axId val="153000192"/>
        <c:scaling>
          <c:orientation val="minMax"/>
          <c:max val="1.2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200" b="1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ell Viability (% of Control)</a:t>
                </a:r>
              </a:p>
            </c:rich>
          </c:tx>
          <c:layout>
            <c:manualLayout>
              <c:xMode val="edge"/>
              <c:yMode val="edge"/>
              <c:x val="1.4163983233439101E-2"/>
              <c:y val="4.2886961163752797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0"/>
        <c:majorTickMark val="cross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2998656"/>
        <c:crosses val="autoZero"/>
        <c:crossBetween val="between"/>
        <c:majorUnit val="0.30000000000000004"/>
      </c:valAx>
      <c:spPr>
        <a:noFill/>
        <a:ln w="12700">
          <a:noFill/>
        </a:ln>
        <a:effectLst/>
      </c:spPr>
    </c:plotArea>
    <c:legend>
      <c:legendPos val="r"/>
      <c:layout>
        <c:manualLayout>
          <c:xMode val="edge"/>
          <c:yMode val="edge"/>
          <c:x val="0.78307157127747096"/>
          <c:y val="3.5591974731972058E-2"/>
          <c:w val="0.18707768245387238"/>
          <c:h val="0.12429592063703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7.9035532994923857E-2"/>
          <c:y val="9.6139237653618634E-2"/>
          <c:w val="0.90912013536379022"/>
          <c:h val="0.57671669750307542"/>
        </c:manualLayout>
      </c:layout>
      <c:barChart>
        <c:barDir val="col"/>
        <c:grouping val="clustered"/>
        <c:varyColors val="0"/>
        <c:ser>
          <c:idx val="0"/>
          <c:order val="0"/>
          <c:tx>
            <c:v>BV2</c:v>
          </c:tx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MTT t-BHP ROS std'!$T$6:$T$16</c:f>
                <c:numCache>
                  <c:formatCode>General</c:formatCode>
                  <c:ptCount val="11"/>
                  <c:pt idx="0">
                    <c:v>1.2214147240116491E-2</c:v>
                  </c:pt>
                  <c:pt idx="1">
                    <c:v>3.3971973351868634E-2</c:v>
                  </c:pt>
                  <c:pt idx="2">
                    <c:v>4.0161590190609948E-2</c:v>
                  </c:pt>
                  <c:pt idx="3">
                    <c:v>3.4192808189113279E-2</c:v>
                  </c:pt>
                  <c:pt idx="4">
                    <c:v>3.8179076691854982E-2</c:v>
                  </c:pt>
                  <c:pt idx="5">
                    <c:v>4.2865117133813468E-2</c:v>
                  </c:pt>
                  <c:pt idx="6">
                    <c:v>4.0640998844738284E-2</c:v>
                  </c:pt>
                  <c:pt idx="7">
                    <c:v>2.3742500078098354E-2</c:v>
                  </c:pt>
                  <c:pt idx="8">
                    <c:v>4.3595791943900265E-2</c:v>
                  </c:pt>
                  <c:pt idx="9">
                    <c:v>4.0640998844738284E-2</c:v>
                  </c:pt>
                  <c:pt idx="10">
                    <c:v>2.2989321429390426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MTT t-BHP ROS std'!$C$6:$C$16</c:f>
              <c:strCache>
                <c:ptCount val="11"/>
                <c:pt idx="0">
                  <c:v>(-)</c:v>
                </c:pt>
                <c:pt idx="1">
                  <c:v>(+)</c:v>
                </c:pt>
                <c:pt idx="2">
                  <c:v>Galic acid </c:v>
                </c:pt>
                <c:pt idx="3">
                  <c:v>Catechin</c:v>
                </c:pt>
                <c:pt idx="4">
                  <c:v>Epigallo catechin</c:v>
                </c:pt>
                <c:pt idx="5">
                  <c:v>Epicatechin gallate</c:v>
                </c:pt>
                <c:pt idx="6">
                  <c:v>Apigenin</c:v>
                </c:pt>
                <c:pt idx="7">
                  <c:v>Caffeic acid </c:v>
                </c:pt>
                <c:pt idx="8">
                  <c:v>Epicatechin </c:v>
                </c:pt>
                <c:pt idx="9">
                  <c:v>Quercetin</c:v>
                </c:pt>
                <c:pt idx="10">
                  <c:v>NNFE</c:v>
                </c:pt>
              </c:strCache>
            </c:strRef>
          </c:cat>
          <c:val>
            <c:numRef>
              <c:f>'MTT t-BHP ROS std'!$S$6:$S$16</c:f>
              <c:numCache>
                <c:formatCode>0%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0.54965976027510643</c:v>
                </c:pt>
                <c:pt idx="3">
                  <c:v>0.55837568384761316</c:v>
                </c:pt>
                <c:pt idx="4">
                  <c:v>0.62927276381554376</c:v>
                </c:pt>
                <c:pt idx="5">
                  <c:v>0.76377843889488883</c:v>
                </c:pt>
                <c:pt idx="6">
                  <c:v>0.89298339771494895</c:v>
                </c:pt>
                <c:pt idx="7">
                  <c:v>0.15866678151551891</c:v>
                </c:pt>
                <c:pt idx="8">
                  <c:v>0.68336215597799188</c:v>
                </c:pt>
                <c:pt idx="9">
                  <c:v>0.89298339771494895</c:v>
                </c:pt>
                <c:pt idx="10">
                  <c:v>0.1656491500080614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8F0-40ED-B45D-5F0D624F63CD}"/>
            </c:ext>
          </c:extLst>
        </c:ser>
        <c:ser>
          <c:idx val="1"/>
          <c:order val="1"/>
          <c:tx>
            <c:v>Raw 264.7</c:v>
          </c:tx>
          <c:spPr>
            <a:pattFill prst="pct60">
              <a:fgClr>
                <a:schemeClr val="tx1"/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MTT t-BHP ROS std'!$T$20:$T$30</c:f>
                <c:numCache>
                  <c:formatCode>General</c:formatCode>
                  <c:ptCount val="11"/>
                  <c:pt idx="0">
                    <c:v>1.3107034201934101E-2</c:v>
                  </c:pt>
                  <c:pt idx="1">
                    <c:v>3.2173459175079154E-2</c:v>
                  </c:pt>
                  <c:pt idx="2">
                    <c:v>6.2120110934062486E-2</c:v>
                  </c:pt>
                  <c:pt idx="3">
                    <c:v>4.6951478450287312E-2</c:v>
                  </c:pt>
                  <c:pt idx="4">
                    <c:v>5.7505636913259259E-2</c:v>
                  </c:pt>
                  <c:pt idx="5">
                    <c:v>5.0821856170763832E-2</c:v>
                  </c:pt>
                  <c:pt idx="6">
                    <c:v>6.1815491446908441E-2</c:v>
                  </c:pt>
                  <c:pt idx="7">
                    <c:v>6.0354021254913071E-2</c:v>
                  </c:pt>
                  <c:pt idx="8">
                    <c:v>3.8527986920472816E-2</c:v>
                  </c:pt>
                  <c:pt idx="9">
                    <c:v>6.1731529182657612E-2</c:v>
                  </c:pt>
                  <c:pt idx="10">
                    <c:v>5.8178238850930909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MTT t-BHP ROS std'!$C$6:$C$16</c:f>
              <c:strCache>
                <c:ptCount val="11"/>
                <c:pt idx="0">
                  <c:v>(-)</c:v>
                </c:pt>
                <c:pt idx="1">
                  <c:v>(+)</c:v>
                </c:pt>
                <c:pt idx="2">
                  <c:v>Galic acid </c:v>
                </c:pt>
                <c:pt idx="3">
                  <c:v>Catechin</c:v>
                </c:pt>
                <c:pt idx="4">
                  <c:v>Epigallo catechin</c:v>
                </c:pt>
                <c:pt idx="5">
                  <c:v>Epicatechin gallate</c:v>
                </c:pt>
                <c:pt idx="6">
                  <c:v>Apigenin</c:v>
                </c:pt>
                <c:pt idx="7">
                  <c:v>Caffeic acid </c:v>
                </c:pt>
                <c:pt idx="8">
                  <c:v>Epicatechin </c:v>
                </c:pt>
                <c:pt idx="9">
                  <c:v>Quercetin</c:v>
                </c:pt>
                <c:pt idx="10">
                  <c:v>NNFE</c:v>
                </c:pt>
              </c:strCache>
            </c:strRef>
          </c:cat>
          <c:val>
            <c:numRef>
              <c:f>'MTT t-BHP ROS std'!$S$20:$S$30</c:f>
              <c:numCache>
                <c:formatCode>0%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0.46030170254818165</c:v>
                </c:pt>
                <c:pt idx="3">
                  <c:v>0.49873312906966716</c:v>
                </c:pt>
                <c:pt idx="4">
                  <c:v>0.53632749572445171</c:v>
                </c:pt>
                <c:pt idx="5">
                  <c:v>0.75481478640307775</c:v>
                </c:pt>
                <c:pt idx="6">
                  <c:v>0.85558348262028938</c:v>
                </c:pt>
                <c:pt idx="7">
                  <c:v>0.10223975560559363</c:v>
                </c:pt>
                <c:pt idx="8">
                  <c:v>0.62617455368088248</c:v>
                </c:pt>
                <c:pt idx="9">
                  <c:v>0.85896782170399089</c:v>
                </c:pt>
                <c:pt idx="10">
                  <c:v>0.108111207878139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8F0-40ED-B45D-5F0D624F63C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10"/>
        <c:axId val="153078016"/>
        <c:axId val="153083904"/>
      </c:barChart>
      <c:catAx>
        <c:axId val="153078016"/>
        <c:scaling>
          <c:orientation val="minMax"/>
        </c:scaling>
        <c:delete val="0"/>
        <c:axPos val="b"/>
        <c:numFmt formatCode="General" sourceLinked="1"/>
        <c:majorTickMark val="cross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3083904"/>
        <c:crosses val="autoZero"/>
        <c:auto val="1"/>
        <c:lblAlgn val="ctr"/>
        <c:lblOffset val="100"/>
        <c:noMultiLvlLbl val="0"/>
      </c:catAx>
      <c:valAx>
        <c:axId val="153083904"/>
        <c:scaling>
          <c:orientation val="minMax"/>
        </c:scaling>
        <c:delete val="0"/>
        <c:axPos val="l"/>
        <c:numFmt formatCode="General" sourceLinked="0"/>
        <c:majorTickMark val="cross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3078016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7514299640614883"/>
          <c:y val="4.5695783345554457E-4"/>
          <c:w val="0.31482513289899677"/>
          <c:h val="6.365850102070573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277301" cy="33716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5593038" y="0"/>
            <a:ext cx="4277301" cy="33716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3D113AB-7562-4DF8-8BB4-EB2DAD70C627}" type="datetimeFigureOut">
              <a:rPr lang="ko-KR" altLang="en-US" smtClean="0"/>
              <a:t>2017-08-2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6403874"/>
            <a:ext cx="4277301" cy="33715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5593038" y="6403874"/>
            <a:ext cx="4277301" cy="33715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B8BC697-27B6-4DED-8B63-A5492C4A488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185536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278154" cy="33710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592225" y="0"/>
            <a:ext cx="4278154" cy="33710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DD266F8-882A-49E6-91E5-AB532B0C9561}" type="datetimeFigureOut">
              <a:rPr lang="en-US" smtClean="0"/>
              <a:t>8/29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249613" y="504825"/>
            <a:ext cx="3373437" cy="25288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87267" y="3202509"/>
            <a:ext cx="7898130" cy="303395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403837"/>
            <a:ext cx="4278154" cy="33710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592225" y="6403837"/>
            <a:ext cx="4278154" cy="33710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5337233-4AE5-466A-870E-82F5E95E98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53161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337233-4AE5-466A-870E-82F5E95E987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6012930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337233-4AE5-466A-870E-82F5E95E9877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8106695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337233-4AE5-466A-870E-82F5E95E9877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5480526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337233-4AE5-466A-870E-82F5E95E9877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9741221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337233-4AE5-466A-870E-82F5E95E9877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213521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337233-4AE5-466A-870E-82F5E95E9877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900011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337233-4AE5-466A-870E-82F5E95E9877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135557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337233-4AE5-466A-870E-82F5E95E9877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320281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337233-4AE5-466A-870E-82F5E95E9877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9986815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337233-4AE5-466A-870E-82F5E95E9877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6674841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337233-4AE5-466A-870E-82F5E95E9877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2118827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337233-4AE5-466A-870E-82F5E95E9877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5418037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337233-4AE5-466A-870E-82F5E95E9877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23935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82A00E-7254-418B-A0C3-C1A8C5E96C27}" type="datetime1">
              <a:rPr lang="en-US" smtClean="0"/>
              <a:t>8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Biochemistry for medic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4670A-E9C0-4A98-8355-249861E21FD9}" type="datetime1">
              <a:rPr lang="en-US" smtClean="0"/>
              <a:t>8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Biochemistry for medic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79D672-5A1C-4B1B-8FA0-09EFE6A49505}" type="datetime1">
              <a:rPr lang="en-US" smtClean="0"/>
              <a:t>8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Biochemistry for medic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5F892B-5E5E-4147-B062-F5EC1FAD26C4}" type="datetime1">
              <a:rPr lang="en-US" smtClean="0"/>
              <a:t>8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Biochemistry for medic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75ECF-00E7-410D-8EC6-B84F3F5AC6DA}" type="datetime1">
              <a:rPr lang="en-US" smtClean="0"/>
              <a:t>8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Biochemistry for medic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137CD-A2ED-4D32-B655-11849CCF9434}" type="datetime1">
              <a:rPr lang="en-US" smtClean="0"/>
              <a:t>8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Biochemistry for medics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2E964-7044-4367-8C20-6CF86F04959D}" type="datetime1">
              <a:rPr lang="en-US" smtClean="0"/>
              <a:t>8/29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Biochemistry for medics</a:t>
            </a: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ED4FA-249A-42FF-9F6C-B48ED8E7A262}" type="datetime1">
              <a:rPr lang="en-US" smtClean="0"/>
              <a:t>8/29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Biochemistry for medics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824ED4-4CE7-45E0-BA14-44B5BF75A885}" type="datetime1">
              <a:rPr lang="en-US" smtClean="0"/>
              <a:t>8/29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Biochemistry for medic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87638-6046-43DE-BA6F-3AE179AA160E}" type="datetime1">
              <a:rPr lang="en-US" smtClean="0"/>
              <a:t>8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Biochemistry for medics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7EEFB6-1F62-431E-B74E-DCBC2EEA4963}" type="datetime1">
              <a:rPr lang="en-US" smtClean="0"/>
              <a:t>8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Biochemistry for medics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CD9C5D-1A84-47A0-8C86-151647ACFF7B}" type="datetime1">
              <a:rPr lang="en-US" smtClean="0"/>
              <a:t>8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en-US"/>
              <a:t>Biochemistry for medic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7.xml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chart" Target="../charts/chart9.xml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720334" y="774962"/>
            <a:ext cx="5715303" cy="3700922"/>
            <a:chOff x="1720334" y="774962"/>
            <a:chExt cx="5715303" cy="3700922"/>
          </a:xfrm>
        </p:grpSpPr>
        <p:graphicFrame>
          <p:nvGraphicFramePr>
            <p:cNvPr id="9" name="차트 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015034989"/>
                </p:ext>
              </p:extLst>
            </p:nvPr>
          </p:nvGraphicFramePr>
          <p:xfrm>
            <a:off x="1905000" y="774962"/>
            <a:ext cx="5486400" cy="317984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2" name="TextBox 1"/>
            <p:cNvSpPr txBox="1"/>
            <p:nvPr/>
          </p:nvSpPr>
          <p:spPr>
            <a:xfrm>
              <a:off x="1720334" y="976071"/>
              <a:ext cx="369332" cy="2400978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otal Phenolic Content (</a:t>
              </a:r>
              <a:r>
                <a:rPr lang="en-US" altLang="ko-KR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gGAE</a:t>
              </a:r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/g)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7066305" y="980247"/>
              <a:ext cx="369332" cy="2484334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otal Flavonoid Content (</a:t>
              </a:r>
              <a:r>
                <a:rPr lang="en-US" altLang="ko-KR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gCAE</a:t>
              </a:r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/g)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2098022" y="4014219"/>
              <a:ext cx="533761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1. 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otal phenolic content and total flavonoid content of </a:t>
              </a:r>
              <a:r>
                <a:rPr lang="en-US" altLang="ko-KR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ethanolic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extract </a:t>
              </a:r>
            </a:p>
            <a:p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 various organic solution fractions of </a:t>
              </a:r>
              <a:r>
                <a:rPr lang="en-US" altLang="ko-KR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ymphaea </a:t>
              </a:r>
              <a:r>
                <a:rPr lang="en-US" altLang="ko-KR" sz="12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ouchali</a:t>
              </a:r>
              <a:r>
                <a:rPr lang="en-US" altLang="ko-KR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lower.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17046876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4400">
        <p14:honeycomb/>
      </p:transition>
    </mc:Choice>
    <mc:Fallback xmlns="">
      <p:transition spd="slow">
        <p:fade/>
      </p:transition>
    </mc:Fallback>
  </mc:AlternateContent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743200" y="1143000"/>
            <a:ext cx="2609473" cy="1817968"/>
            <a:chOff x="375668" y="775604"/>
            <a:chExt cx="2609473" cy="1817968"/>
          </a:xfrm>
        </p:grpSpPr>
        <p:grpSp>
          <p:nvGrpSpPr>
            <p:cNvPr id="9" name="Group 8"/>
            <p:cNvGrpSpPr/>
            <p:nvPr/>
          </p:nvGrpSpPr>
          <p:grpSpPr>
            <a:xfrm>
              <a:off x="990600" y="775604"/>
              <a:ext cx="1994541" cy="1207992"/>
              <a:chOff x="3586563" y="4295338"/>
              <a:chExt cx="1994541" cy="1207992"/>
            </a:xfrm>
          </p:grpSpPr>
          <p:pic>
            <p:nvPicPr>
              <p:cNvPr id="11" name="Picture 10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587539" y="4295338"/>
                <a:ext cx="1993565" cy="286537"/>
              </a:xfrm>
              <a:prstGeom prst="rect">
                <a:avLst/>
              </a:prstGeom>
            </p:spPr>
          </p:pic>
          <p:pic>
            <p:nvPicPr>
              <p:cNvPr id="13" name="Picture 12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3586563" y="4598719"/>
                <a:ext cx="1993565" cy="286537"/>
              </a:xfrm>
              <a:prstGeom prst="rect">
                <a:avLst/>
              </a:prstGeom>
            </p:spPr>
          </p:pic>
          <p:pic>
            <p:nvPicPr>
              <p:cNvPr id="14" name="Picture 13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3586563" y="4905153"/>
                <a:ext cx="1993565" cy="286537"/>
              </a:xfrm>
              <a:prstGeom prst="rect">
                <a:avLst/>
              </a:prstGeom>
            </p:spPr>
          </p:pic>
          <p:pic>
            <p:nvPicPr>
              <p:cNvPr id="16" name="Picture 15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586983" y="5216793"/>
                <a:ext cx="1993565" cy="286537"/>
              </a:xfrm>
              <a:prstGeom prst="rect">
                <a:avLst/>
              </a:prstGeom>
            </p:spPr>
          </p:pic>
        </p:grpSp>
        <p:sp>
          <p:nvSpPr>
            <p:cNvPr id="19" name="TextBox 18"/>
            <p:cNvSpPr txBox="1"/>
            <p:nvPr/>
          </p:nvSpPr>
          <p:spPr>
            <a:xfrm>
              <a:off x="492002" y="780589"/>
              <a:ext cx="5004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od1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580306" y="1062141"/>
              <a:ext cx="4074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t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414802" y="1392640"/>
              <a:ext cx="5774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px-1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375668" y="1693858"/>
              <a:ext cx="6110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b="1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apdh</a:t>
              </a:r>
              <a:endPara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462265" y="1962244"/>
              <a:ext cx="247851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-BHP    -         +         +        +        +      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642098" y="2316573"/>
              <a:ext cx="228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    -         -           -         -        +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449580" y="2148175"/>
              <a:ext cx="247851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NFE    -         -                               -</a:t>
              </a:r>
            </a:p>
          </p:txBody>
        </p:sp>
        <p:sp>
          <p:nvSpPr>
            <p:cNvPr id="27" name="Right Triangle 26"/>
            <p:cNvSpPr/>
            <p:nvPr/>
          </p:nvSpPr>
          <p:spPr>
            <a:xfrm flipH="1">
              <a:off x="1752600" y="2182289"/>
              <a:ext cx="762000" cy="132844"/>
            </a:xfrm>
            <a:prstGeom prst="rtTriangle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sp>
        <p:nvSpPr>
          <p:cNvPr id="204" name="TextBox 203"/>
          <p:cNvSpPr txBox="1"/>
          <p:nvPr/>
        </p:nvSpPr>
        <p:spPr>
          <a:xfrm>
            <a:off x="990600" y="3089701"/>
            <a:ext cx="727112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0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 of NNFE on primary antioxidant enzyme in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BHP-induced BV2 cells. Cells were pretreated for 12 h with specified concentrations of NNFE followed by 12 h of treatment with 100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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BHP. The primary antioxidant enzyme mRNA expression were analyzed by RT-PCR. Concentration of NNFE (3 and 10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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/mL) was applied from left to right. CA: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ffeic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id 5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M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  </a:t>
            </a:r>
            <a:endParaRPr lang="ko-KR" alt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332484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4400">
        <p14:honeycomb/>
      </p:transition>
    </mc:Choice>
    <mc:Fallback xmlns="">
      <p:transition spd="slow">
        <p:fade/>
      </p:transition>
    </mc:Fallback>
  </mc:AlternateContent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936439" y="914400"/>
            <a:ext cx="7271122" cy="3258815"/>
            <a:chOff x="936439" y="914400"/>
            <a:chExt cx="7271122" cy="3258815"/>
          </a:xfrm>
        </p:grpSpPr>
        <p:grpSp>
          <p:nvGrpSpPr>
            <p:cNvPr id="150" name="Group 149"/>
            <p:cNvGrpSpPr/>
            <p:nvPr/>
          </p:nvGrpSpPr>
          <p:grpSpPr>
            <a:xfrm>
              <a:off x="2743200" y="914400"/>
              <a:ext cx="2318014" cy="2295733"/>
              <a:chOff x="4997187" y="766803"/>
              <a:chExt cx="2318014" cy="2295733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5703530" y="771051"/>
                <a:ext cx="1611670" cy="286537"/>
              </a:xfrm>
              <a:prstGeom prst="rect">
                <a:avLst/>
              </a:prstGeom>
            </p:spPr>
          </p:pic>
          <p:pic>
            <p:nvPicPr>
              <p:cNvPr id="6" name="Picture 5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5703531" y="1067421"/>
                <a:ext cx="1611670" cy="286537"/>
              </a:xfrm>
              <a:prstGeom prst="rect">
                <a:avLst/>
              </a:prstGeom>
            </p:spPr>
          </p:pic>
          <p:pic>
            <p:nvPicPr>
              <p:cNvPr id="130" name="Picture 129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5703530" y="1380097"/>
                <a:ext cx="1609483" cy="286537"/>
              </a:xfrm>
              <a:prstGeom prst="rect">
                <a:avLst/>
              </a:prstGeom>
            </p:spPr>
          </p:pic>
          <p:pic>
            <p:nvPicPr>
              <p:cNvPr id="132" name="Picture 131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5703530" y="1683134"/>
                <a:ext cx="1609483" cy="286537"/>
              </a:xfrm>
              <a:prstGeom prst="rect">
                <a:avLst/>
              </a:prstGeom>
            </p:spPr>
          </p:pic>
          <p:pic>
            <p:nvPicPr>
              <p:cNvPr id="134" name="Picture 133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5703530" y="1982836"/>
                <a:ext cx="1609483" cy="286537"/>
              </a:xfrm>
              <a:prstGeom prst="rect">
                <a:avLst/>
              </a:prstGeom>
            </p:spPr>
          </p:pic>
          <p:pic>
            <p:nvPicPr>
              <p:cNvPr id="136" name="Picture 135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5697433" y="2297856"/>
                <a:ext cx="1615580" cy="286537"/>
              </a:xfrm>
              <a:prstGeom prst="rect">
                <a:avLst/>
              </a:prstGeom>
            </p:spPr>
          </p:pic>
          <p:sp>
            <p:nvSpPr>
              <p:cNvPr id="137" name="TextBox 136"/>
              <p:cNvSpPr txBox="1"/>
              <p:nvPr/>
            </p:nvSpPr>
            <p:spPr>
              <a:xfrm>
                <a:off x="4997187" y="766803"/>
                <a:ext cx="70724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2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mox-1</a:t>
                </a:r>
              </a:p>
            </p:txBody>
          </p:sp>
          <p:sp>
            <p:nvSpPr>
              <p:cNvPr id="142" name="TextBox 141"/>
              <p:cNvSpPr txBox="1"/>
              <p:nvPr/>
            </p:nvSpPr>
            <p:spPr>
              <a:xfrm>
                <a:off x="5393404" y="2785537"/>
                <a:ext cx="191960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A    -          -         -         +</a:t>
                </a:r>
              </a:p>
            </p:txBody>
          </p:sp>
          <p:sp>
            <p:nvSpPr>
              <p:cNvPr id="143" name="TextBox 142"/>
              <p:cNvSpPr txBox="1"/>
              <p:nvPr/>
            </p:nvSpPr>
            <p:spPr>
              <a:xfrm>
                <a:off x="5194704" y="2584723"/>
                <a:ext cx="211830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NFE    -                               -                                                   </a:t>
                </a:r>
              </a:p>
            </p:txBody>
          </p:sp>
          <p:sp>
            <p:nvSpPr>
              <p:cNvPr id="144" name="TextBox 143"/>
              <p:cNvSpPr txBox="1"/>
              <p:nvPr/>
            </p:nvSpPr>
            <p:spPr>
              <a:xfrm>
                <a:off x="5170885" y="1077275"/>
                <a:ext cx="52610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2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qo1</a:t>
                </a:r>
              </a:p>
            </p:txBody>
          </p:sp>
          <p:sp>
            <p:nvSpPr>
              <p:cNvPr id="145" name="TextBox 144"/>
              <p:cNvSpPr txBox="1"/>
              <p:nvPr/>
            </p:nvSpPr>
            <p:spPr>
              <a:xfrm>
                <a:off x="5227081" y="1398916"/>
                <a:ext cx="47641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200" b="1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clc</a:t>
                </a:r>
                <a:endParaRPr lang="en-US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6" name="TextBox 145"/>
              <p:cNvSpPr txBox="1"/>
              <p:nvPr/>
            </p:nvSpPr>
            <p:spPr>
              <a:xfrm>
                <a:off x="5170428" y="1702619"/>
                <a:ext cx="52770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200" b="1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clm</a:t>
                </a:r>
                <a:endParaRPr lang="en-US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7" name="TextBox 146"/>
              <p:cNvSpPr txBox="1"/>
              <p:nvPr/>
            </p:nvSpPr>
            <p:spPr>
              <a:xfrm>
                <a:off x="5184976" y="1992588"/>
                <a:ext cx="51809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200" b="1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stpi</a:t>
                </a:r>
                <a:endParaRPr lang="en-US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8" name="TextBox 147"/>
              <p:cNvSpPr txBox="1"/>
              <p:nvPr/>
            </p:nvSpPr>
            <p:spPr>
              <a:xfrm>
                <a:off x="5089492" y="2308575"/>
                <a:ext cx="61106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200" b="1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pdh</a:t>
                </a:r>
                <a:endParaRPr lang="en-US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9" name="Right Triangle 148"/>
              <p:cNvSpPr/>
              <p:nvPr/>
            </p:nvSpPr>
            <p:spPr>
              <a:xfrm flipH="1">
                <a:off x="6096000" y="2623847"/>
                <a:ext cx="770610" cy="97957"/>
              </a:xfrm>
              <a:prstGeom prst="rtTriangl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sp>
          <p:nvSpPr>
            <p:cNvPr id="46" name="TextBox 45"/>
            <p:cNvSpPr txBox="1"/>
            <p:nvPr/>
          </p:nvSpPr>
          <p:spPr>
            <a:xfrm>
              <a:off x="936439" y="3342218"/>
              <a:ext cx="7271122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11. 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ffect of NNFE on phase II </a:t>
              </a:r>
              <a:r>
                <a:rPr lang="en-US" altLang="ko-KR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ntioxidiant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nd detoxifying enzyme in BV2 cells. Cells were pretreated for 24 h with specified concentrations of NNFE. The mRNA expression of phase II antioxidant and detoxifying enzyme were analyzed by RT-PCR. Concentration of NNFE (3 and 10 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  <a:sym typeface="Symbol" panose="05050102010706020507" pitchFamily="18" charset="2"/>
                </a:rPr>
                <a:t>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/mL) was applied from left to right. CA: </a:t>
              </a:r>
              <a:r>
                <a:rPr lang="en-US" altLang="ko-KR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affeic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cid 5 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  <a:sym typeface="Symbol" panose="05050102010706020507" pitchFamily="18" charset="2"/>
                </a:rPr>
                <a:t>M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endParaRPr lang="ko-KR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3644137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4400">
        <p14:honeycomb/>
      </p:transition>
    </mc:Choice>
    <mc:Fallback xmlns="">
      <p:transition spd="slow">
        <p:fade/>
      </p:transition>
    </mc:Fallback>
  </mc:AlternateContent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876300" y="914400"/>
            <a:ext cx="7391400" cy="2434237"/>
            <a:chOff x="876300" y="914400"/>
            <a:chExt cx="7391400" cy="2434237"/>
          </a:xfrm>
        </p:grpSpPr>
        <p:grpSp>
          <p:nvGrpSpPr>
            <p:cNvPr id="203" name="Group 202"/>
            <p:cNvGrpSpPr/>
            <p:nvPr/>
          </p:nvGrpSpPr>
          <p:grpSpPr>
            <a:xfrm>
              <a:off x="3048000" y="914400"/>
              <a:ext cx="2222701" cy="1402426"/>
              <a:chOff x="4856971" y="3818362"/>
              <a:chExt cx="2222701" cy="1402426"/>
            </a:xfrm>
          </p:grpSpPr>
          <p:pic>
            <p:nvPicPr>
              <p:cNvPr id="192" name="Picture 191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5470151" y="3818362"/>
                <a:ext cx="1609520" cy="288000"/>
              </a:xfrm>
              <a:prstGeom prst="rect">
                <a:avLst/>
              </a:prstGeom>
            </p:spPr>
          </p:pic>
          <p:pic>
            <p:nvPicPr>
              <p:cNvPr id="194" name="Picture 193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5465288" y="4119920"/>
                <a:ext cx="1614384" cy="288000"/>
              </a:xfrm>
              <a:prstGeom prst="rect">
                <a:avLst/>
              </a:prstGeom>
            </p:spPr>
          </p:pic>
          <p:pic>
            <p:nvPicPr>
              <p:cNvPr id="196" name="Picture 195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5467782" y="4427376"/>
                <a:ext cx="1611889" cy="288000"/>
              </a:xfrm>
              <a:prstGeom prst="rect">
                <a:avLst/>
              </a:prstGeom>
            </p:spPr>
          </p:pic>
          <p:sp>
            <p:nvSpPr>
              <p:cNvPr id="197" name="TextBox 196"/>
              <p:cNvSpPr txBox="1"/>
              <p:nvPr/>
            </p:nvSpPr>
            <p:spPr>
              <a:xfrm>
                <a:off x="4984118" y="4128839"/>
                <a:ext cx="48282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2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rf2</a:t>
                </a:r>
              </a:p>
            </p:txBody>
          </p:sp>
          <p:sp>
            <p:nvSpPr>
              <p:cNvPr id="198" name="TextBox 197"/>
              <p:cNvSpPr txBox="1"/>
              <p:nvPr/>
            </p:nvSpPr>
            <p:spPr>
              <a:xfrm>
                <a:off x="4881142" y="3833590"/>
                <a:ext cx="58702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2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eap1</a:t>
                </a:r>
              </a:p>
            </p:txBody>
          </p:sp>
          <p:sp>
            <p:nvSpPr>
              <p:cNvPr id="199" name="TextBox 198"/>
              <p:cNvSpPr txBox="1"/>
              <p:nvPr/>
            </p:nvSpPr>
            <p:spPr>
              <a:xfrm>
                <a:off x="4856971" y="4441620"/>
                <a:ext cx="61106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200" b="1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pdh</a:t>
                </a:r>
                <a:endParaRPr lang="en-US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0" name="TextBox 199"/>
              <p:cNvSpPr txBox="1"/>
              <p:nvPr/>
            </p:nvSpPr>
            <p:spPr>
              <a:xfrm>
                <a:off x="5160062" y="4943789"/>
                <a:ext cx="191960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A    -          -         -         +</a:t>
                </a:r>
              </a:p>
            </p:txBody>
          </p:sp>
          <p:sp>
            <p:nvSpPr>
              <p:cNvPr id="201" name="TextBox 200"/>
              <p:cNvSpPr txBox="1"/>
              <p:nvPr/>
            </p:nvSpPr>
            <p:spPr>
              <a:xfrm>
                <a:off x="4961362" y="4742975"/>
                <a:ext cx="211830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NFE    -                               -                                                   </a:t>
                </a:r>
              </a:p>
            </p:txBody>
          </p:sp>
          <p:sp>
            <p:nvSpPr>
              <p:cNvPr id="202" name="Right Triangle 201"/>
              <p:cNvSpPr/>
              <p:nvPr/>
            </p:nvSpPr>
            <p:spPr>
              <a:xfrm flipH="1">
                <a:off x="5862658" y="4782099"/>
                <a:ext cx="770610" cy="97957"/>
              </a:xfrm>
              <a:prstGeom prst="rtTriangl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sp>
          <p:nvSpPr>
            <p:cNvPr id="52" name="TextBox 51"/>
            <p:cNvSpPr txBox="1"/>
            <p:nvPr/>
          </p:nvSpPr>
          <p:spPr>
            <a:xfrm>
              <a:off x="876300" y="2517640"/>
              <a:ext cx="7391400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12. 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ffect of NNFE on phase II </a:t>
              </a:r>
              <a:r>
                <a:rPr lang="en-US" altLang="ko-KR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ntioxidiant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nd detoxifying enzyme transcription factor nuclear factor erythroid 2-related factor 2 (NRF2) and </a:t>
              </a:r>
              <a:r>
                <a:rPr lang="en-US" altLang="ko-KR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elch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like ECH-associated protein 1 (Keap1) in BV2 cells. Cells were pretreated for 24 h with specified concentrations of NNFE. The mRNA expression of Keap1 and Nrf2 were analyzed by RT-PCR. Concentration of NNFE (3 and 10 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  <a:sym typeface="Symbol" panose="05050102010706020507" pitchFamily="18" charset="2"/>
                </a:rPr>
                <a:t>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/mL) was applied from left to right. CA: </a:t>
              </a:r>
              <a:r>
                <a:rPr lang="en-US" altLang="ko-KR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affeic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cid 5 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  <a:sym typeface="Symbol" panose="05050102010706020507" pitchFamily="18" charset="2"/>
                </a:rPr>
                <a:t>M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   </a:t>
              </a:r>
              <a:endParaRPr lang="ko-KR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28732406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4400">
        <p14:honeycomb/>
      </p:transition>
    </mc:Choice>
    <mc:Fallback xmlns="">
      <p:transition spd="slow">
        <p:fade/>
      </p:transition>
    </mc:Fallback>
  </mc:AlternateContent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72354836"/>
              </p:ext>
            </p:extLst>
          </p:nvPr>
        </p:nvGraphicFramePr>
        <p:xfrm>
          <a:off x="2268721" y="457200"/>
          <a:ext cx="4665479" cy="6273215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05747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1806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78993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68149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name</a:t>
                      </a:r>
                      <a:endParaRPr lang="ko-KR" sz="1200" b="1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ko-KR" sz="1200" b="1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quences</a:t>
                      </a:r>
                      <a:endParaRPr lang="ko-KR" sz="1200" b="1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99857"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d1</a:t>
                      </a:r>
                      <a:endParaRPr lang="ko-KR" sz="1200" i="1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ko-KR" sz="12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GCGGTGAACCAGTTGTGT</a:t>
                      </a:r>
                      <a:endParaRPr lang="ko-KR" sz="120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814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ko-KR" sz="12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CAATGATGGAATGCTCTC</a:t>
                      </a:r>
                      <a:endParaRPr lang="ko-KR" sz="120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68149"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px1</a:t>
                      </a:r>
                      <a:endParaRPr lang="ko-KR" sz="1200" i="1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ko-KR" sz="12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ACCGAGATGAACGATCTG</a:t>
                      </a:r>
                      <a:endParaRPr lang="ko-KR" sz="120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6814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ko-KR" sz="12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GTACTTGGGGTCGGTCAT</a:t>
                      </a:r>
                      <a:endParaRPr lang="ko-KR" sz="120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99857"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</a:t>
                      </a:r>
                      <a:endParaRPr lang="ko-KR" sz="1200" i="1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ko-KR" sz="12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CCCACGATATCACCAGATAC</a:t>
                      </a:r>
                      <a:endParaRPr lang="ko-KR" sz="120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99857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ko-KR" sz="12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AGACTCCAGAAGTCCCAGAC</a:t>
                      </a:r>
                      <a:endParaRPr lang="ko-KR" sz="120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68149"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mox-1</a:t>
                      </a:r>
                      <a:endParaRPr lang="ko-KR" sz="1200" i="1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ko-KR" sz="12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GCATATACCCGCTACCTG</a:t>
                      </a:r>
                      <a:endParaRPr lang="ko-KR" sz="120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6814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ko-KR" sz="12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CTCTGTCAGCATCACCTG</a:t>
                      </a:r>
                      <a:endParaRPr lang="ko-KR" sz="120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68149"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i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lc</a:t>
                      </a:r>
                      <a:endParaRPr lang="ko-KR" sz="1200" i="1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ko-KR" sz="12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AGGCGATGTTCTTGAGAC</a:t>
                      </a:r>
                      <a:endParaRPr lang="ko-KR" sz="120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6814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ko-KR" sz="12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GTGCTTGTTTATGGCTTC</a:t>
                      </a:r>
                      <a:endParaRPr lang="ko-KR" sz="12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68149"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i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lm</a:t>
                      </a:r>
                      <a:endParaRPr lang="ko-KR" sz="1200" i="1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ko-KR" sz="12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TTGCACAGCTGGACTCTG</a:t>
                      </a:r>
                      <a:endParaRPr lang="ko-KR" sz="120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6814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ko-KR" sz="12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GGGTCATTGTGAGTCAGT</a:t>
                      </a:r>
                      <a:endParaRPr lang="ko-KR" sz="120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99857"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qo-1</a:t>
                      </a:r>
                      <a:endParaRPr lang="ko-KR" sz="1200" i="1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ko-KR" sz="12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GGCCCATTCAGAGAAGAC</a:t>
                      </a:r>
                      <a:endParaRPr lang="ko-KR" sz="120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6814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ko-KR" sz="12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CTGCAGCTTCCAGCTTCT</a:t>
                      </a:r>
                      <a:endParaRPr lang="ko-KR" sz="120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68149"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rf-2</a:t>
                      </a:r>
                      <a:endParaRPr lang="ko-KR" sz="1200" i="1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ko-KR" sz="12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ATCCTTTGGAGGCAAGAC</a:t>
                      </a:r>
                      <a:endParaRPr lang="ko-KR" sz="120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99857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ko-KR" sz="12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GAATGTCTCTGCCAAAAG</a:t>
                      </a:r>
                      <a:endParaRPr lang="ko-KR" sz="120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68149"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i="1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stpi</a:t>
                      </a:r>
                      <a:endParaRPr lang="ko-KR" sz="1200" i="1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ko-KR" sz="12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CCAGATGGATATGGTGAA</a:t>
                      </a:r>
                      <a:endParaRPr lang="ko-KR" sz="120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6814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ko-KR" sz="12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GGGACGGTTCACATGTTC</a:t>
                      </a:r>
                      <a:endParaRPr lang="ko-KR" sz="120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68149"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i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eap1</a:t>
                      </a:r>
                      <a:endParaRPr lang="ko-KR" sz="1200" i="1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ko-KR" sz="12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TACAACCCCATGACCAAC</a:t>
                      </a:r>
                      <a:endParaRPr lang="ko-KR" sz="120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68149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ko-KR" sz="12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GGAGTTAAGCCGGTTAGT</a:t>
                      </a:r>
                      <a:endParaRPr lang="ko-KR" sz="12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68149">
                <a:tc rowSpan="2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ko-KR" sz="1200" i="1" dirty="0" err="1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Gapdh</a:t>
                      </a:r>
                      <a:endParaRPr lang="ko-KR" sz="1200" i="1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50" charset="-127"/>
                          <a:cs typeface="Times New Roman" panose="02020603050405020304" pitchFamily="18" charset="0"/>
                        </a:rPr>
                        <a:t>Forward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50" charset="-127"/>
                          <a:cs typeface="Times New Roman" panose="02020603050405020304" pitchFamily="18" charset="0"/>
                        </a:rPr>
                        <a:t>TTGTGATGGGTGTGAACCAC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68149">
                <a:tc vMerge="1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ko-KR" sz="1200" i="1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51538" marR="51538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50" charset="-127"/>
                          <a:cs typeface="Times New Roman" panose="02020603050405020304" pitchFamily="18" charset="0"/>
                        </a:rPr>
                        <a:t>reverse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50" charset="-127"/>
                          <a:cs typeface="Times New Roman" panose="02020603050405020304" pitchFamily="18" charset="0"/>
                        </a:rPr>
                        <a:t>ACACATTGGGGGTAGGAACA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</a:tbl>
          </a:graphicData>
        </a:graphic>
      </p:graphicFrame>
      <p:sp>
        <p:nvSpPr>
          <p:cNvPr id="6" name="Rectangle 5"/>
          <p:cNvSpPr/>
          <p:nvPr/>
        </p:nvSpPr>
        <p:spPr>
          <a:xfrm>
            <a:off x="2811745" y="0"/>
            <a:ext cx="3320076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304800" indent="-304800" algn="just">
              <a:lnSpc>
                <a:spcPct val="200000"/>
              </a:lnSpc>
              <a:spcAft>
                <a:spcPts val="0"/>
              </a:spcAft>
            </a:pPr>
            <a:r>
              <a:rPr lang="en-US" altLang="ko-KR" sz="1200" b="1" dirty="0">
                <a:latin typeface="Times New Roman" panose="02020603050405020304" pitchFamily="18" charset="0"/>
              </a:rPr>
              <a:t>Table S1. </a:t>
            </a:r>
            <a:r>
              <a:rPr lang="en-US" altLang="ko-KR" sz="1200" dirty="0">
                <a:latin typeface="Times New Roman" panose="02020603050405020304" pitchFamily="18" charset="0"/>
              </a:rPr>
              <a:t>List of the primer sets used in this study.</a:t>
            </a:r>
            <a:endParaRPr lang="ko-KR" altLang="ko-KR" sz="1200" dirty="0">
              <a:latin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6267226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4400">
        <p14:honeycomb/>
      </p:transition>
    </mc:Choice>
    <mc:Fallback xmlns="">
      <p:transition spd="slow">
        <p:fade/>
      </p:transition>
    </mc:Fallback>
  </mc:AlternateContent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533400" y="1140821"/>
            <a:ext cx="8161028" cy="3623413"/>
            <a:chOff x="533400" y="1140821"/>
            <a:chExt cx="8161028" cy="3623413"/>
          </a:xfrm>
        </p:grpSpPr>
        <p:sp>
          <p:nvSpPr>
            <p:cNvPr id="14" name="TextBox 13"/>
            <p:cNvSpPr txBox="1"/>
            <p:nvPr/>
          </p:nvSpPr>
          <p:spPr>
            <a:xfrm>
              <a:off x="8140430" y="1290485"/>
              <a:ext cx="553998" cy="2409827"/>
            </a:xfrm>
            <a:prstGeom prst="rect">
              <a:avLst/>
            </a:prstGeom>
            <a:noFill/>
          </p:spPr>
          <p:txBody>
            <a:bodyPr vert="vert" wrap="none" rtlCol="0">
              <a:spAutoFit/>
            </a:bodyPr>
            <a:lstStyle/>
            <a:p>
              <a:pPr algn="ctr"/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BTS Radical Scavenging Activity </a:t>
              </a:r>
            </a:p>
            <a:p>
              <a:pPr algn="ctr"/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% inhibition)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3" name="Group 2"/>
            <p:cNvGrpSpPr/>
            <p:nvPr/>
          </p:nvGrpSpPr>
          <p:grpSpPr>
            <a:xfrm>
              <a:off x="533400" y="1140821"/>
              <a:ext cx="7696200" cy="3623413"/>
              <a:chOff x="533400" y="1140821"/>
              <a:chExt cx="7696200" cy="3623413"/>
            </a:xfrm>
          </p:grpSpPr>
          <p:sp>
            <p:nvSpPr>
              <p:cNvPr id="2" name="TextBox 1"/>
              <p:cNvSpPr txBox="1"/>
              <p:nvPr/>
            </p:nvSpPr>
            <p:spPr>
              <a:xfrm>
                <a:off x="533400" y="1173863"/>
                <a:ext cx="553998" cy="2429063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PPH Radical Scavenging Activity </a:t>
                </a:r>
              </a:p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% inhibition)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aphicFrame>
            <p:nvGraphicFramePr>
              <p:cNvPr id="17" name="Chart 16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4242469250"/>
                  </p:ext>
                </p:extLst>
              </p:nvPr>
            </p:nvGraphicFramePr>
            <p:xfrm>
              <a:off x="869308" y="1140821"/>
              <a:ext cx="7360292" cy="289777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19" name="TextBox 18"/>
              <p:cNvSpPr txBox="1"/>
              <p:nvPr/>
            </p:nvSpPr>
            <p:spPr>
              <a:xfrm>
                <a:off x="869308" y="4117903"/>
                <a:ext cx="7271122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igure S2. </a:t>
                </a:r>
                <a:r>
                  <a:rPr lang="en-US" altLang="ko-K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PPH- and ABTS-radical scavenging activities of </a:t>
                </a:r>
                <a:r>
                  <a:rPr lang="en-US" altLang="ko-KR" sz="12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thanolic</a:t>
                </a:r>
                <a:r>
                  <a:rPr lang="en-US" altLang="ko-K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extract and various organic solution fractions of </a:t>
                </a:r>
                <a:r>
                  <a:rPr lang="en-US" altLang="ko-KR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ymphaea </a:t>
                </a:r>
                <a:r>
                  <a:rPr lang="en-US" altLang="ko-KR" sz="12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uchali</a:t>
                </a:r>
                <a:r>
                  <a:rPr lang="en-US" altLang="ko-KR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ko-K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lower</a:t>
                </a:r>
                <a:r>
                  <a:rPr lang="en-US" altLang="ko-KR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. </a:t>
                </a:r>
                <a:r>
                  <a:rPr lang="en-US" altLang="ko-K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alues are expressed as the mean </a:t>
                </a:r>
                <a:r>
                  <a:rPr lang="en-US" altLang="ko-KR" sz="1200" dirty="0">
                    <a:latin typeface="Times New Roman" panose="02020603050405020304" pitchFamily="18" charset="0"/>
                    <a:cs typeface="Times New Roman" panose="02020603050405020304" pitchFamily="18" charset="0"/>
                    <a:sym typeface="Symbol" panose="05050102010706020507" pitchFamily="18" charset="2"/>
                  </a:rPr>
                  <a:t></a:t>
                </a:r>
                <a:r>
                  <a:rPr lang="en-US" altLang="ko-K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SD (n=3).  *</a:t>
                </a:r>
                <a:r>
                  <a:rPr lang="en-US" altLang="ko-KR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en-US" altLang="ko-K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&lt; 0.05 and **</a:t>
                </a:r>
                <a:r>
                  <a:rPr lang="en-US" altLang="ko-KR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en-US" altLang="ko-K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&lt; 0.01, significantly different from control, using student’s </a:t>
                </a:r>
                <a:r>
                  <a:rPr lang="en-US" altLang="ko-KR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ko-K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test. </a:t>
                </a:r>
                <a:endParaRPr lang="ko-KR" alt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80701387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4400">
        <p14:honeycomb/>
      </p:transition>
    </mc:Choice>
    <mc:Fallback xmlns="">
      <p:transition spd="slow">
        <p:fade/>
      </p:transition>
    </mc:Fallback>
  </mc:AlternateContent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533400" y="1123798"/>
            <a:ext cx="8097798" cy="4048017"/>
            <a:chOff x="533400" y="1123798"/>
            <a:chExt cx="8097798" cy="4048017"/>
          </a:xfrm>
        </p:grpSpPr>
        <p:sp>
          <p:nvSpPr>
            <p:cNvPr id="2" name="TextBox 1"/>
            <p:cNvSpPr txBox="1"/>
            <p:nvPr/>
          </p:nvSpPr>
          <p:spPr>
            <a:xfrm>
              <a:off x="533400" y="1303554"/>
              <a:ext cx="553998" cy="2631490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pPr algn="ctr"/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ydroxyl Radical Scavenging Activity </a:t>
              </a:r>
            </a:p>
            <a:p>
              <a:pPr algn="ctr"/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% inhibition)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8077200" y="1303554"/>
              <a:ext cx="553998" cy="2750112"/>
            </a:xfrm>
            <a:prstGeom prst="rect">
              <a:avLst/>
            </a:prstGeom>
            <a:noFill/>
          </p:spPr>
          <p:txBody>
            <a:bodyPr vert="vert" wrap="none" rtlCol="0">
              <a:spAutoFit/>
            </a:bodyPr>
            <a:lstStyle/>
            <a:p>
              <a:pPr algn="ctr"/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eroxide Radical Scavenging Activity </a:t>
              </a:r>
            </a:p>
            <a:p>
              <a:pPr algn="ctr"/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% inhibition)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7" name="Chart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199293188"/>
                </p:ext>
              </p:extLst>
            </p:nvPr>
          </p:nvGraphicFramePr>
          <p:xfrm>
            <a:off x="914400" y="1123798"/>
            <a:ext cx="7226030" cy="299100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8" name="TextBox 7"/>
            <p:cNvSpPr txBox="1"/>
            <p:nvPr/>
          </p:nvSpPr>
          <p:spPr>
            <a:xfrm>
              <a:off x="914400" y="4340818"/>
              <a:ext cx="7271122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3. 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ydroxyl- and superoxide-radical scavenging activities of </a:t>
              </a:r>
              <a:r>
                <a:rPr lang="en-US" altLang="ko-KR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ethanolic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extract and various organic solution fractions of </a:t>
              </a:r>
              <a:r>
                <a:rPr lang="en-US" altLang="ko-KR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ymphaea </a:t>
              </a:r>
              <a:r>
                <a:rPr lang="en-US" altLang="ko-KR" sz="12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ouchali</a:t>
              </a:r>
              <a:r>
                <a:rPr lang="en-US" altLang="ko-KR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lower.</a:t>
              </a:r>
              <a:r>
                <a:rPr lang="en-US" altLang="ko-KR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alues are expressed as the mean 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  <a:sym typeface="Symbol" panose="05050102010706020507" pitchFamily="18" charset="2"/>
                </a:rPr>
                <a:t>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SD (</a:t>
              </a:r>
              <a:r>
                <a:rPr lang="en-US" altLang="ko-KR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 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= 3).  *</a:t>
              </a:r>
              <a:r>
                <a:rPr lang="en-US" altLang="ko-KR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&lt; 0.05 and **</a:t>
              </a:r>
              <a:r>
                <a:rPr lang="en-US" altLang="ko-KR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&lt; 0.01, significantly different from control, using student’s </a:t>
              </a:r>
              <a:r>
                <a:rPr lang="en-US" altLang="ko-KR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test. </a:t>
              </a:r>
              <a:r>
                <a:rPr lang="en-US" altLang="ko-KR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td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Gallic acid (3,10, and 30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  <a:sym typeface="Symbol" panose="05050102010706020507" pitchFamily="18" charset="2"/>
                </a:rPr>
                <a:t>g/mL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for superoxide-radical scavenging activity; Quercetin (0.3, 1, and 3 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  <a:sym typeface="Symbol" panose="05050102010706020507" pitchFamily="18" charset="2"/>
                </a:rPr>
                <a:t>g/mL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for hydroxyl-radical scavenging activity.  </a:t>
              </a:r>
              <a:endParaRPr lang="ko-KR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6950952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4400">
        <p14:honeycomb/>
      </p:transition>
    </mc:Choice>
    <mc:Fallback xmlns="">
      <p:transition spd="slow">
        <p:fade/>
      </p:transition>
    </mc:Fallback>
  </mc:AlternateContent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738107" y="993733"/>
            <a:ext cx="7731166" cy="3713825"/>
            <a:chOff x="738107" y="993733"/>
            <a:chExt cx="7731166" cy="3713825"/>
          </a:xfrm>
        </p:grpSpPr>
        <p:graphicFrame>
          <p:nvGraphicFramePr>
            <p:cNvPr id="13" name="Chart 1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673788975"/>
                </p:ext>
              </p:extLst>
            </p:nvPr>
          </p:nvGraphicFramePr>
          <p:xfrm>
            <a:off x="1143000" y="993733"/>
            <a:ext cx="6772275" cy="286039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4" name="TextBox 13"/>
            <p:cNvSpPr txBox="1"/>
            <p:nvPr/>
          </p:nvSpPr>
          <p:spPr>
            <a:xfrm>
              <a:off x="7915275" y="1494569"/>
              <a:ext cx="553998" cy="1768626"/>
            </a:xfrm>
            <a:prstGeom prst="rect">
              <a:avLst/>
            </a:prstGeom>
            <a:noFill/>
          </p:spPr>
          <p:txBody>
            <a:bodyPr vert="vert" wrap="none" rtlCol="0">
              <a:spAutoFit/>
            </a:bodyPr>
            <a:lstStyle/>
            <a:p>
              <a:pPr algn="ctr"/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scorbic Acid Equivalent</a:t>
              </a:r>
            </a:p>
            <a:p>
              <a:pPr algn="ctr"/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FRAP Value (</a:t>
              </a:r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  <a:sym typeface="Symbol" panose="05050102010706020507" pitchFamily="18" charset="2"/>
                </a:rPr>
                <a:t>M</a:t>
              </a:r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738107" y="1494570"/>
              <a:ext cx="553998" cy="1807098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pPr algn="ctr"/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scorbic Acid Equivalent </a:t>
              </a:r>
            </a:p>
            <a:p>
              <a:pPr algn="ctr"/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UPRAC Value (</a:t>
              </a:r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  <a:sym typeface="Symbol" panose="05050102010706020507" pitchFamily="18" charset="2"/>
                </a:rPr>
                <a:t>M</a:t>
              </a:r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990600" y="4061227"/>
              <a:ext cx="7271122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4. 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lectron donating capacities of </a:t>
              </a:r>
              <a:r>
                <a:rPr lang="en-US" altLang="ko-KR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ethanolic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extract and various organic solution fractions of </a:t>
              </a:r>
              <a:r>
                <a:rPr lang="en-US" altLang="ko-KR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ymphaea </a:t>
              </a:r>
              <a:r>
                <a:rPr lang="en-US" altLang="ko-KR" sz="12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ouchali</a:t>
              </a:r>
              <a:r>
                <a:rPr lang="en-US" altLang="ko-KR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lower in CUPRAC and FRAP assays</a:t>
              </a:r>
              <a:r>
                <a:rPr lang="en-US" altLang="ko-KR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alues are expressed as the mean 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  <a:sym typeface="Symbol" panose="05050102010706020507" pitchFamily="18" charset="2"/>
                </a:rPr>
                <a:t>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SD (</a:t>
              </a:r>
              <a:r>
                <a:rPr lang="en-US" altLang="ko-KR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 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= 3).  *</a:t>
              </a:r>
              <a:r>
                <a:rPr lang="en-US" altLang="ko-KR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&lt; 0.05 and **</a:t>
              </a:r>
              <a:r>
                <a:rPr lang="en-US" altLang="ko-KR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&lt; 0.01, significantly different from control, using student’s </a:t>
              </a:r>
              <a:r>
                <a:rPr lang="en-US" altLang="ko-KR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test. </a:t>
              </a:r>
              <a:endParaRPr lang="ko-KR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11359298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4400">
        <p14:honeycomb/>
      </p:transition>
    </mc:Choice>
    <mc:Fallback xmlns="">
      <p:transition spd="slow">
        <p:fade/>
      </p:transition>
    </mc:Fallback>
  </mc:AlternateContent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01564299"/>
              </p:ext>
            </p:extLst>
          </p:nvPr>
        </p:nvGraphicFramePr>
        <p:xfrm>
          <a:off x="1828800" y="1219200"/>
          <a:ext cx="6096000" cy="2819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4" name="TextBox 13"/>
          <p:cNvSpPr txBox="1"/>
          <p:nvPr/>
        </p:nvSpPr>
        <p:spPr>
          <a:xfrm>
            <a:off x="1469196" y="1279623"/>
            <a:ext cx="369332" cy="2552365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pPr algn="ctr"/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olox Equivalent ORAC Value (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M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143000" y="4340403"/>
            <a:ext cx="727112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AC activities of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hanolic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tract and various organic solution fractions of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ymphaea </a:t>
            </a:r>
            <a:r>
              <a:rPr lang="en-US" altLang="ko-KR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ouchali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lower.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lues are expressed as the mean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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D (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3).  *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 and **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1, significantly different from control, using student’s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est. </a:t>
            </a:r>
            <a:endParaRPr lang="ko-KR" alt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111097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4400">
        <p14:honeycomb/>
      </p:transition>
    </mc:Choice>
    <mc:Fallback xmlns="">
      <p:transition spd="slow">
        <p:fade/>
      </p:transition>
    </mc:Fallback>
  </mc:AlternateContent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219200" y="609600"/>
            <a:ext cx="7271122" cy="3802797"/>
            <a:chOff x="1219200" y="609600"/>
            <a:chExt cx="7271122" cy="3802797"/>
          </a:xfrm>
        </p:grpSpPr>
        <p:sp>
          <p:nvSpPr>
            <p:cNvPr id="7" name="TextBox 6"/>
            <p:cNvSpPr txBox="1"/>
            <p:nvPr/>
          </p:nvSpPr>
          <p:spPr>
            <a:xfrm>
              <a:off x="1219200" y="3581400"/>
              <a:ext cx="7271122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6. 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adical scavenging activities of the identified major constituents and </a:t>
              </a:r>
              <a:r>
                <a:rPr lang="en-US" altLang="ko-KR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thylacetate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fraction of </a:t>
              </a:r>
              <a:r>
                <a:rPr lang="en-US" altLang="ko-KR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ymphaea </a:t>
              </a:r>
              <a:r>
                <a:rPr lang="en-US" altLang="ko-KR" sz="12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ouchali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flower.</a:t>
              </a:r>
              <a:r>
                <a:rPr lang="en-US" altLang="ko-KR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alues are expressed as the mean 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  <a:sym typeface="Symbol" panose="05050102010706020507" pitchFamily="18" charset="2"/>
                </a:rPr>
                <a:t>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SD (</a:t>
              </a:r>
              <a:r>
                <a:rPr lang="en-US" altLang="ko-KR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 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= 3).  The experimental concentration of gallic acid </a:t>
              </a:r>
            </a:p>
            <a:p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 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  <a:sym typeface="Symbol" panose="05050102010706020507" pitchFamily="18" charset="2"/>
                </a:rPr>
                <a:t>M; catechin 3 M; epigallocatechin 2 M; epicatechin gallate 4 M; epicatechin 2 M; caffeic acid 5 M, quercetin 1 M; apigenin 2 M and NNFE 5 g/</a:t>
              </a:r>
              <a:r>
                <a:rPr lang="en-US" altLang="ko-KR" sz="1200" dirty="0" err="1">
                  <a:latin typeface="Times New Roman" panose="02020603050405020304" pitchFamily="18" charset="0"/>
                  <a:cs typeface="Times New Roman" panose="02020603050405020304" pitchFamily="18" charset="0"/>
                  <a:sym typeface="Symbol" panose="05050102010706020507" pitchFamily="18" charset="2"/>
                </a:rPr>
                <a:t>mL.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  <a:sym typeface="Symbol" panose="05050102010706020507" pitchFamily="18" charset="2"/>
                </a:rPr>
                <a:t> </a:t>
              </a:r>
              <a:endParaRPr lang="ko-KR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5" name="Chart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845908178"/>
                </p:ext>
              </p:extLst>
            </p:nvPr>
          </p:nvGraphicFramePr>
          <p:xfrm>
            <a:off x="1600200" y="609600"/>
            <a:ext cx="5791200" cy="304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236676714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4400">
        <p14:honeycomb/>
      </p:transition>
    </mc:Choice>
    <mc:Fallback xmlns="">
      <p:transition spd="slow">
        <p:fade/>
      </p:transition>
    </mc:Fallback>
  </mc:AlternateContent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143000" y="609600"/>
            <a:ext cx="7271122" cy="3922931"/>
            <a:chOff x="1143000" y="609600"/>
            <a:chExt cx="7271122" cy="3922931"/>
          </a:xfrm>
        </p:grpSpPr>
        <p:graphicFrame>
          <p:nvGraphicFramePr>
            <p:cNvPr id="19" name="Chart 1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862566647"/>
                </p:ext>
              </p:extLst>
            </p:nvPr>
          </p:nvGraphicFramePr>
          <p:xfrm>
            <a:off x="1447800" y="609600"/>
            <a:ext cx="6248400" cy="3124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20" name="TextBox 19"/>
            <p:cNvSpPr txBox="1"/>
            <p:nvPr/>
          </p:nvSpPr>
          <p:spPr>
            <a:xfrm>
              <a:off x="1143000" y="3886200"/>
              <a:ext cx="7271122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7.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Effect of </a:t>
              </a:r>
              <a:r>
                <a:rPr lang="en-US" altLang="ko-KR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thylacetate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fractions of </a:t>
              </a:r>
              <a:r>
                <a:rPr lang="en-US" altLang="ko-KR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ymphaea </a:t>
              </a:r>
              <a:r>
                <a:rPr lang="en-US" altLang="ko-KR" sz="12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ouchali</a:t>
              </a:r>
              <a:r>
                <a:rPr lang="en-US" altLang="ko-KR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lower (NNFE) on cell viability of RAW 264.7 and BV2 Cells. Cells were treated with various concentration of NNFE for 24 h and cells viability was measured by MTT assay. </a:t>
              </a:r>
              <a:endParaRPr lang="ko-KR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4391412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4400">
        <p14:honeycomb/>
      </p:transition>
    </mc:Choice>
    <mc:Fallback xmlns="">
      <p:transition spd="slow">
        <p:fade/>
      </p:transition>
    </mc:Fallback>
  </mc:AlternateContent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143000" y="762000"/>
            <a:ext cx="7271122" cy="3585865"/>
            <a:chOff x="1143000" y="762000"/>
            <a:chExt cx="7271122" cy="3585865"/>
          </a:xfrm>
        </p:grpSpPr>
        <p:graphicFrame>
          <p:nvGraphicFramePr>
            <p:cNvPr id="12" name="Chart 1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753390139"/>
                </p:ext>
              </p:extLst>
            </p:nvPr>
          </p:nvGraphicFramePr>
          <p:xfrm>
            <a:off x="1381125" y="762000"/>
            <a:ext cx="6381750" cy="280987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6" name="TextBox 5"/>
            <p:cNvSpPr txBox="1"/>
            <p:nvPr/>
          </p:nvSpPr>
          <p:spPr>
            <a:xfrm>
              <a:off x="1143000" y="3886200"/>
              <a:ext cx="727112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8. 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ffect of </a:t>
              </a:r>
              <a:r>
                <a:rPr lang="en-US" altLang="ko-KR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BHP on cell viability in RAW 264.7. Cells were treated at 3, 6, 12 and 24 h with different concentration of </a:t>
              </a:r>
              <a:r>
                <a:rPr lang="en-US" altLang="ko-KR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BHP and cell viability was determined by MTT assay. </a:t>
              </a:r>
              <a:endParaRPr lang="ko-KR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108590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4400">
        <p14:honeycomb/>
      </p:transition>
    </mc:Choice>
    <mc:Fallback xmlns="">
      <p:transition spd="slow">
        <p:fade/>
      </p:transition>
    </mc:Fallback>
  </mc:AlternateContent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244183" y="685800"/>
            <a:ext cx="6781800" cy="4370821"/>
            <a:chOff x="1244183" y="685800"/>
            <a:chExt cx="6781800" cy="4370821"/>
          </a:xfrm>
        </p:grpSpPr>
        <p:sp>
          <p:nvSpPr>
            <p:cNvPr id="6" name="TextBox 5"/>
            <p:cNvSpPr txBox="1"/>
            <p:nvPr/>
          </p:nvSpPr>
          <p:spPr>
            <a:xfrm>
              <a:off x="1244183" y="3856292"/>
              <a:ext cx="6781800" cy="1200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9.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Cells were treated for 12 h with the sample before treatment with 100 </a:t>
              </a:r>
              <a:r>
                <a:rPr lang="en-US" altLang="ko-KR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μM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ko-KR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BHP. Intracellular ROS was measured by monitoring the DCF fluorescence intensity for RAW 264.7 cells and BV2 cells. Values are expressed as the mean 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  <a:sym typeface="Symbol" panose="05050102010706020507" pitchFamily="18" charset="2"/>
                </a:rPr>
                <a:t>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SD (</a:t>
              </a:r>
              <a:r>
                <a:rPr lang="en-US" altLang="ko-KR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= 3). #</a:t>
              </a:r>
              <a:r>
                <a:rPr lang="en-US" altLang="ko-KR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&lt; 0.001 compared to control, **</a:t>
              </a:r>
              <a:r>
                <a:rPr lang="en-US" altLang="ko-KR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&lt; 0.05 compared to </a:t>
              </a:r>
            </a:p>
            <a:p>
              <a:pPr algn="just"/>
              <a:r>
                <a:rPr lang="en-US" altLang="ko-KR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BHP treatment. Statistical analysis was carried out using student’s </a:t>
              </a:r>
              <a:r>
                <a:rPr lang="en-US" altLang="ko-KR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test. The experimental concentration of gallic acid 2 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  <a:sym typeface="Symbol" panose="05050102010706020507" pitchFamily="18" charset="2"/>
                </a:rPr>
                <a:t>M; catechin 3 M; epigallocatechin 2 M; epicatechin gallate 4 M; epicatechin 2 M; caffeic acid 5 M, quercetin 1 M; apigenin 2 M and NNFE 10 g/</a:t>
              </a:r>
              <a:r>
                <a:rPr lang="en-US" altLang="ko-KR" sz="1200" dirty="0" err="1">
                  <a:latin typeface="Times New Roman" panose="02020603050405020304" pitchFamily="18" charset="0"/>
                  <a:cs typeface="Times New Roman" panose="02020603050405020304" pitchFamily="18" charset="0"/>
                  <a:sym typeface="Symbol" panose="05050102010706020507" pitchFamily="18" charset="2"/>
                </a:rPr>
                <a:t>mL.</a:t>
              </a:r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  <a:sym typeface="Symbol" panose="05050102010706020507" pitchFamily="18" charset="2"/>
                </a:rPr>
                <a:t> </a:t>
              </a:r>
              <a:endParaRPr lang="ko-KR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39" name="Group 38"/>
            <p:cNvGrpSpPr/>
            <p:nvPr/>
          </p:nvGrpSpPr>
          <p:grpSpPr>
            <a:xfrm>
              <a:off x="1244183" y="685800"/>
              <a:ext cx="6472237" cy="3043668"/>
              <a:chOff x="1295400" y="838200"/>
              <a:chExt cx="6472237" cy="3043668"/>
            </a:xfrm>
          </p:grpSpPr>
          <p:graphicFrame>
            <p:nvGraphicFramePr>
              <p:cNvPr id="4" name="Chart 3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644928970"/>
                  </p:ext>
                </p:extLst>
              </p:nvPr>
            </p:nvGraphicFramePr>
            <p:xfrm>
              <a:off x="1676400" y="838200"/>
              <a:ext cx="6091237" cy="272891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5" name="TextBox 4"/>
              <p:cNvSpPr txBox="1"/>
              <p:nvPr/>
            </p:nvSpPr>
            <p:spPr>
              <a:xfrm>
                <a:off x="1295400" y="1121359"/>
                <a:ext cx="553998" cy="1806392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ellular ROS Generation </a:t>
                </a:r>
              </a:p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% of Control)</a:t>
                </a:r>
              </a:p>
            </p:txBody>
          </p:sp>
          <p:grpSp>
            <p:nvGrpSpPr>
              <p:cNvPr id="7" name="Group 6"/>
              <p:cNvGrpSpPr/>
              <p:nvPr/>
            </p:nvGrpSpPr>
            <p:grpSpPr>
              <a:xfrm>
                <a:off x="2303488" y="1113020"/>
                <a:ext cx="5228558" cy="1371600"/>
                <a:chOff x="2303488" y="1113020"/>
                <a:chExt cx="5228558" cy="1371600"/>
              </a:xfrm>
            </p:grpSpPr>
            <p:cxnSp>
              <p:nvCxnSpPr>
                <p:cNvPr id="3" name="Straight Connector 2"/>
                <p:cNvCxnSpPr/>
                <p:nvPr/>
              </p:nvCxnSpPr>
              <p:spPr>
                <a:xfrm>
                  <a:off x="2438400" y="1120515"/>
                  <a:ext cx="381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" name="Straight Connector 7"/>
                <p:cNvCxnSpPr/>
                <p:nvPr/>
              </p:nvCxnSpPr>
              <p:spPr>
                <a:xfrm>
                  <a:off x="2978046" y="1120515"/>
                  <a:ext cx="4428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" name="Straight Connector 8"/>
                <p:cNvCxnSpPr/>
                <p:nvPr/>
              </p:nvCxnSpPr>
              <p:spPr>
                <a:xfrm>
                  <a:off x="2437151" y="1113020"/>
                  <a:ext cx="0" cy="13716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" name="Straight Connector 9"/>
                <p:cNvCxnSpPr/>
                <p:nvPr/>
              </p:nvCxnSpPr>
              <p:spPr>
                <a:xfrm>
                  <a:off x="7280046" y="2268766"/>
                  <a:ext cx="252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" name="Straight Connector 10"/>
                <p:cNvCxnSpPr/>
                <p:nvPr/>
              </p:nvCxnSpPr>
              <p:spPr>
                <a:xfrm>
                  <a:off x="2303488" y="2484619"/>
                  <a:ext cx="252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" name="Straight Connector 12"/>
                <p:cNvCxnSpPr/>
                <p:nvPr/>
              </p:nvCxnSpPr>
              <p:spPr>
                <a:xfrm>
                  <a:off x="2811905" y="1120514"/>
                  <a:ext cx="0" cy="144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" name="Straight Connector 13"/>
                <p:cNvCxnSpPr/>
                <p:nvPr/>
              </p:nvCxnSpPr>
              <p:spPr>
                <a:xfrm>
                  <a:off x="2978046" y="1116313"/>
                  <a:ext cx="0" cy="144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" name="Straight Connector 14"/>
                <p:cNvCxnSpPr/>
                <p:nvPr/>
              </p:nvCxnSpPr>
              <p:spPr>
                <a:xfrm>
                  <a:off x="2770347" y="1260313"/>
                  <a:ext cx="252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" name="Straight Connector 15"/>
                <p:cNvCxnSpPr/>
                <p:nvPr/>
              </p:nvCxnSpPr>
              <p:spPr>
                <a:xfrm>
                  <a:off x="3426501" y="1113020"/>
                  <a:ext cx="0" cy="648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" name="Straight Connector 16"/>
                <p:cNvCxnSpPr/>
                <p:nvPr/>
              </p:nvCxnSpPr>
              <p:spPr>
                <a:xfrm>
                  <a:off x="3891196" y="1113020"/>
                  <a:ext cx="0" cy="648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" name="Straight Connector 17"/>
                <p:cNvCxnSpPr/>
                <p:nvPr/>
              </p:nvCxnSpPr>
              <p:spPr>
                <a:xfrm>
                  <a:off x="4468317" y="1113020"/>
                  <a:ext cx="0" cy="576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" name="Straight Connector 18"/>
                <p:cNvCxnSpPr/>
                <p:nvPr/>
              </p:nvCxnSpPr>
              <p:spPr>
                <a:xfrm>
                  <a:off x="4925517" y="1113020"/>
                  <a:ext cx="0" cy="360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" name="Straight Connector 19"/>
                <p:cNvCxnSpPr/>
                <p:nvPr/>
              </p:nvCxnSpPr>
              <p:spPr>
                <a:xfrm>
                  <a:off x="5441430" y="1113020"/>
                  <a:ext cx="0" cy="216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" name="Straight Connector 20"/>
                <p:cNvCxnSpPr/>
                <p:nvPr/>
              </p:nvCxnSpPr>
              <p:spPr>
                <a:xfrm>
                  <a:off x="5959839" y="1120515"/>
                  <a:ext cx="0" cy="1152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" name="Straight Connector 21"/>
                <p:cNvCxnSpPr/>
                <p:nvPr/>
              </p:nvCxnSpPr>
              <p:spPr>
                <a:xfrm>
                  <a:off x="7413885" y="1120514"/>
                  <a:ext cx="0" cy="1152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" name="Straight Connector 22"/>
                <p:cNvCxnSpPr/>
                <p:nvPr/>
              </p:nvCxnSpPr>
              <p:spPr>
                <a:xfrm>
                  <a:off x="6447018" y="1113020"/>
                  <a:ext cx="0" cy="504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" name="Straight Connector 23"/>
                <p:cNvCxnSpPr/>
                <p:nvPr/>
              </p:nvCxnSpPr>
              <p:spPr>
                <a:xfrm>
                  <a:off x="6940446" y="1120515"/>
                  <a:ext cx="0" cy="216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" name="Straight Connector 24"/>
                <p:cNvCxnSpPr/>
                <p:nvPr/>
              </p:nvCxnSpPr>
              <p:spPr>
                <a:xfrm>
                  <a:off x="3292840" y="1765091"/>
                  <a:ext cx="252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" name="Straight Connector 25"/>
                <p:cNvCxnSpPr/>
                <p:nvPr/>
              </p:nvCxnSpPr>
              <p:spPr>
                <a:xfrm>
                  <a:off x="3765030" y="1765091"/>
                  <a:ext cx="252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" name="Straight Connector 26"/>
                <p:cNvCxnSpPr/>
                <p:nvPr/>
              </p:nvCxnSpPr>
              <p:spPr>
                <a:xfrm>
                  <a:off x="4319666" y="1690141"/>
                  <a:ext cx="252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" name="Straight Connector 27"/>
                <p:cNvCxnSpPr/>
                <p:nvPr/>
              </p:nvCxnSpPr>
              <p:spPr>
                <a:xfrm>
                  <a:off x="4799351" y="1472783"/>
                  <a:ext cx="252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" name="Straight Connector 28"/>
                <p:cNvCxnSpPr/>
                <p:nvPr/>
              </p:nvCxnSpPr>
              <p:spPr>
                <a:xfrm>
                  <a:off x="5301522" y="1337872"/>
                  <a:ext cx="252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" name="Straight Connector 30"/>
                <p:cNvCxnSpPr/>
                <p:nvPr/>
              </p:nvCxnSpPr>
              <p:spPr>
                <a:xfrm>
                  <a:off x="5818683" y="2274757"/>
                  <a:ext cx="252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" name="Straight Connector 31"/>
                <p:cNvCxnSpPr/>
                <p:nvPr/>
              </p:nvCxnSpPr>
              <p:spPr>
                <a:xfrm>
                  <a:off x="6320853" y="1622685"/>
                  <a:ext cx="252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" name="Straight Connector 32"/>
                <p:cNvCxnSpPr/>
                <p:nvPr/>
              </p:nvCxnSpPr>
              <p:spPr>
                <a:xfrm>
                  <a:off x="6808033" y="1345367"/>
                  <a:ext cx="252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34" name="Straight Connector 33"/>
              <p:cNvCxnSpPr/>
              <p:nvPr/>
            </p:nvCxnSpPr>
            <p:spPr>
              <a:xfrm>
                <a:off x="2186066" y="3626371"/>
                <a:ext cx="551013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" name="TextBox 35"/>
              <p:cNvSpPr txBox="1"/>
              <p:nvPr/>
            </p:nvSpPr>
            <p:spPr>
              <a:xfrm>
                <a:off x="4179694" y="3604869"/>
                <a:ext cx="12393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</a:t>
                </a:r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BHP (100</a:t>
                </a:r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  <a:sym typeface="Symbol" panose="05050102010706020507" pitchFamily="18" charset="2"/>
                  </a:rPr>
                  <a:t>M</a:t>
                </a:r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2486065" y="911313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#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4943630" y="911314"/>
                <a:ext cx="33855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69424203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4400">
        <p14:honeycomb/>
      </p:transition>
    </mc:Choice>
    <mc:Fallback xmlns="">
      <p:transition spd="slow">
        <p:fade/>
      </p:transition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862</TotalTime>
  <Words>1095</Words>
  <Application>Microsoft Office PowerPoint</Application>
  <PresentationFormat>On-screen Show (4:3)</PresentationFormat>
  <Paragraphs>188</Paragraphs>
  <Slides>13</Slides>
  <Notes>13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20" baseType="lpstr">
      <vt:lpstr>Arial Unicode MS</vt:lpstr>
      <vt:lpstr>맑은 고딕</vt:lpstr>
      <vt:lpstr>Arial</vt:lpstr>
      <vt:lpstr>Calibri</vt:lpstr>
      <vt:lpstr>Symbo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user</dc:creator>
  <cp:lastModifiedBy>Windows User</cp:lastModifiedBy>
  <cp:revision>1163</cp:revision>
  <cp:lastPrinted>2015-08-27T11:31:26Z</cp:lastPrinted>
  <dcterms:created xsi:type="dcterms:W3CDTF">2006-08-16T00:00:00Z</dcterms:created>
  <dcterms:modified xsi:type="dcterms:W3CDTF">2017-08-29T13:23:52Z</dcterms:modified>
</cp:coreProperties>
</file>